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85" r:id="rId2"/>
    <p:sldId id="282" r:id="rId3"/>
    <p:sldId id="280" r:id="rId4"/>
    <p:sldId id="281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63AFF"/>
    <a:srgbClr val="14B6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328"/>
    <p:restoredTop sz="94683"/>
  </p:normalViewPr>
  <p:slideViewPr>
    <p:cSldViewPr snapToGrid="0" snapToObjects="1">
      <p:cViewPr>
        <p:scale>
          <a:sx n="90" d="100"/>
          <a:sy n="90" d="100"/>
        </p:scale>
        <p:origin x="-2632" y="-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%201:Users:Dr.Sankar:Desktop:bk2pg14_virus%20release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%201:Users:Dr.Sankar:Desktop:qPCR_Nrf2%20and%20Keap1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%201:Users:Dr.Sankar:Desktop:qPCR_Nrf2%20and%20Keap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askaran\Desktop\Figures_2020\Figure%202\Na%20Butyrate%20Exp\27-Feb-2020.xls" TargetMode="External"/><Relationship Id="rId2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%201:Users:Dr.Sankar:Downloads:bk2pg98_Nrf2_transcriptome%20genes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%201:Users:Dr.Sankar:Downloads:bk2pg98_Nrf2_transcriptome%20genes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%201:Users:Dr.Sankar:Downloads:bk2pg98_Nrf2_transcriptome%20genes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%201:Users:Dr.Sankar:Desktop:lab%20records:q-PCR%20:bk2pg93_round%201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%201:Users:Dr.Sankar:Desktop:lab%20records:q-PCR%20:bk2pg93_Round%202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%201:Users:Dr.Sankar:Desktop:lab%20records:q-PCR%20:bk2pg93_round%201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%201:Users:Dr.Sankar:Desktop:lab%20records:q-PCR%20:BK2PG68%20RE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72670636075501"/>
          <c:y val="0.0820596700259748"/>
          <c:w val="0.423937952542028"/>
          <c:h val="0.79279979471236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T$53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6350" cmpd="sng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T$60:$T$61</c:f>
                <c:numCache>
                  <c:formatCode>General</c:formatCode>
                  <c:ptCount val="2"/>
                  <c:pt idx="0">
                    <c:v>0.0111004159244493</c:v>
                  </c:pt>
                  <c:pt idx="1">
                    <c:v>0.0424540869745765</c:v>
                  </c:pt>
                </c:numCache>
              </c:numRef>
            </c:plus>
            <c:minus>
              <c:numRef>
                <c:f>Sheet1!$T$60:$T$61</c:f>
                <c:numCache>
                  <c:formatCode>General</c:formatCode>
                  <c:ptCount val="2"/>
                  <c:pt idx="0">
                    <c:v>0.0111004159244493</c:v>
                  </c:pt>
                  <c:pt idx="1">
                    <c:v>0.0424540869745765</c:v>
                  </c:pt>
                </c:numCache>
              </c:numRef>
            </c:minus>
            <c:spPr>
              <a:ln w="3175">
                <a:solidFill>
                  <a:srgbClr val="333333"/>
                </a:solidFill>
                <a:prstDash val="solid"/>
              </a:ln>
            </c:spPr>
          </c:errBars>
          <c:cat>
            <c:strRef>
              <c:f>Sheet1!$S$54:$S$55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Sheet1!$T$54:$T$55</c:f>
              <c:numCache>
                <c:formatCode>General</c:formatCode>
                <c:ptCount val="2"/>
                <c:pt idx="0">
                  <c:v>0.600209715991649</c:v>
                </c:pt>
                <c:pt idx="1">
                  <c:v>1.208963084193492</c:v>
                </c:pt>
              </c:numCache>
            </c:numRef>
          </c:val>
        </c:ser>
        <c:ser>
          <c:idx val="1"/>
          <c:order val="1"/>
          <c:tx>
            <c:strRef>
              <c:f>Sheet1!$U$53</c:f>
              <c:strCache>
                <c:ptCount val="1"/>
                <c:pt idx="0">
                  <c:v>PMA</c:v>
                </c:pt>
              </c:strCache>
            </c:strRef>
          </c:tx>
          <c:spPr>
            <a:solidFill>
              <a:schemeClr val="tx1"/>
            </a:solidFill>
            <a:ln w="6350" cmpd="sng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U$61</c:f>
                <c:numCache>
                  <c:formatCode>General</c:formatCode>
                  <c:ptCount val="1"/>
                  <c:pt idx="0">
                    <c:v>0.122972600817108</c:v>
                  </c:pt>
                </c:numCache>
              </c:numRef>
            </c:plus>
            <c:minus>
              <c:numRef>
                <c:f>Sheet1!$U$60:$U$61</c:f>
                <c:numCache>
                  <c:formatCode>General</c:formatCode>
                  <c:ptCount val="2"/>
                  <c:pt idx="0">
                    <c:v>0.0126357007647369</c:v>
                  </c:pt>
                  <c:pt idx="1">
                    <c:v>0.122972600817108</c:v>
                  </c:pt>
                </c:numCache>
              </c:numRef>
            </c:minus>
            <c:spPr>
              <a:ln w="3175">
                <a:solidFill>
                  <a:srgbClr val="333333"/>
                </a:solidFill>
                <a:prstDash val="solid"/>
              </a:ln>
            </c:spPr>
          </c:errBars>
          <c:cat>
            <c:strRef>
              <c:f>Sheet1!$S$54:$S$55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Sheet1!$U$54:$U$55</c:f>
              <c:numCache>
                <c:formatCode>General</c:formatCode>
                <c:ptCount val="2"/>
                <c:pt idx="0">
                  <c:v>0.883650470351864</c:v>
                </c:pt>
                <c:pt idx="1">
                  <c:v>3.4982326177263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12653928"/>
        <c:axId val="1913450680"/>
      </c:barChart>
      <c:catAx>
        <c:axId val="191265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13450680"/>
        <c:crosses val="autoZero"/>
        <c:auto val="1"/>
        <c:lblAlgn val="ctr"/>
        <c:lblOffset val="100"/>
        <c:noMultiLvlLbl val="0"/>
      </c:catAx>
      <c:valAx>
        <c:axId val="19134506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Times New Roman"/>
                    <a:cs typeface="Times New Roman"/>
                  </a:defRPr>
                </a:pPr>
                <a:r>
                  <a:rPr lang="en-US" sz="800" b="0" i="0" baseline="0" dirty="0" smtClean="0">
                    <a:effectLst/>
                    <a:latin typeface="Times New Roman"/>
                    <a:cs typeface="Times New Roman"/>
                  </a:rPr>
                  <a:t>Mean(log</a:t>
                </a:r>
                <a:r>
                  <a:rPr lang="en-US" sz="800" b="0" i="0" baseline="-25000" dirty="0" smtClean="0">
                    <a:effectLst/>
                    <a:latin typeface="Times New Roman"/>
                    <a:cs typeface="Times New Roman"/>
                  </a:rPr>
                  <a:t>10</a:t>
                </a:r>
                <a:r>
                  <a:rPr lang="en-US" sz="800" b="0" i="0" baseline="0" dirty="0" smtClean="0">
                    <a:effectLst/>
                    <a:latin typeface="Times New Roman"/>
                    <a:cs typeface="Times New Roman"/>
                  </a:rPr>
                  <a:t>) relative fold change in DENV RNA level </a:t>
                </a:r>
                <a:endParaRPr lang="en-US" sz="800" dirty="0">
                  <a:effectLst/>
                  <a:latin typeface="Times New Roman"/>
                  <a:cs typeface="Times New Roman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/>
                <a:ea typeface="+mn-ea"/>
                <a:cs typeface="Times New Roman"/>
              </a:defRPr>
            </a:pPr>
            <a:endParaRPr lang="en-US"/>
          </a:p>
        </c:txPr>
        <c:crossAx val="1912653928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65902126082801"/>
          <c:y val="0.0234705425168781"/>
          <c:w val="0.217979943035166"/>
          <c:h val="0.188528288310958"/>
        </c:manualLayout>
      </c:layout>
      <c:overlay val="0"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 dirty="0">
                <a:latin typeface="Times New Roman"/>
                <a:cs typeface="Times New Roman"/>
              </a:rPr>
              <a:t>NRF2</a:t>
            </a:r>
          </a:p>
        </c:rich>
      </c:tx>
      <c:layout>
        <c:manualLayout>
          <c:xMode val="edge"/>
          <c:yMode val="edge"/>
          <c:x val="0.436534444444444"/>
          <c:y val="0.033597883597883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330217222222222"/>
          <c:y val="0.0783950617283951"/>
          <c:w val="0.578060555555556"/>
          <c:h val="0.802052910052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rf2'!$F$113</c:f>
              <c:strCache>
                <c:ptCount val="1"/>
                <c:pt idx="0">
                  <c:v>MOCK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rf2'!$F$120:$F$121</c:f>
                <c:numCache>
                  <c:formatCode>General</c:formatCode>
                  <c:ptCount val="2"/>
                  <c:pt idx="0">
                    <c:v>0.204517149869481</c:v>
                  </c:pt>
                  <c:pt idx="1">
                    <c:v>0.204517149869481</c:v>
                  </c:pt>
                </c:numCache>
              </c:numRef>
            </c:plus>
            <c:minus>
              <c:numRef>
                <c:f>'Nrf2'!$F$120:$F$121</c:f>
                <c:numCache>
                  <c:formatCode>General</c:formatCode>
                  <c:ptCount val="2"/>
                  <c:pt idx="0">
                    <c:v>0.204517149869481</c:v>
                  </c:pt>
                  <c:pt idx="1">
                    <c:v>0.204517149869481</c:v>
                  </c:pt>
                </c:numCache>
              </c:numRef>
            </c:minus>
          </c:errBars>
          <c:cat>
            <c:strRef>
              <c:f>'Nrf2'!$E$114:$E$115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Nrf2'!$F$114:$F$115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FAE-4584-9501-BF573665D3DE}"/>
            </c:ext>
          </c:extLst>
        </c:ser>
        <c:ser>
          <c:idx val="1"/>
          <c:order val="1"/>
          <c:tx>
            <c:strRef>
              <c:f>'Nrf2'!$G$113</c:f>
              <c:strCache>
                <c:ptCount val="1"/>
                <c:pt idx="0">
                  <c:v>PM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rf2'!$G$120:$G$121</c:f>
                <c:numCache>
                  <c:formatCode>General</c:formatCode>
                  <c:ptCount val="2"/>
                  <c:pt idx="0">
                    <c:v>0.0274068085873229</c:v>
                  </c:pt>
                  <c:pt idx="1">
                    <c:v>0.129587745167142</c:v>
                  </c:pt>
                </c:numCache>
              </c:numRef>
            </c:plus>
            <c:minus>
              <c:numRef>
                <c:f>'Nrf2'!$G$120:$G$121</c:f>
                <c:numCache>
                  <c:formatCode>General</c:formatCode>
                  <c:ptCount val="2"/>
                  <c:pt idx="0">
                    <c:v>0.0274068085873229</c:v>
                  </c:pt>
                  <c:pt idx="1">
                    <c:v>0.129587745167142</c:v>
                  </c:pt>
                </c:numCache>
              </c:numRef>
            </c:minus>
          </c:errBars>
          <c:cat>
            <c:strRef>
              <c:f>'Nrf2'!$E$114:$E$115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Nrf2'!$G$114:$G$115</c:f>
              <c:numCache>
                <c:formatCode>General</c:formatCode>
                <c:ptCount val="2"/>
                <c:pt idx="0">
                  <c:v>1.192012817981618</c:v>
                </c:pt>
                <c:pt idx="1">
                  <c:v>1.3808487000056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FAE-4584-9501-BF573665D3DE}"/>
            </c:ext>
          </c:extLst>
        </c:ser>
        <c:ser>
          <c:idx val="2"/>
          <c:order val="2"/>
          <c:tx>
            <c:strRef>
              <c:f>'Nrf2'!$H$113</c:f>
              <c:strCache>
                <c:ptCount val="1"/>
                <c:pt idx="0">
                  <c:v>PMA+DV2 MOI 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rf2'!$H$120:$H$121</c:f>
                <c:numCache>
                  <c:formatCode>General</c:formatCode>
                  <c:ptCount val="2"/>
                  <c:pt idx="0">
                    <c:v>0.0824719313179827</c:v>
                  </c:pt>
                  <c:pt idx="1">
                    <c:v>0.374276509787858</c:v>
                  </c:pt>
                </c:numCache>
              </c:numRef>
            </c:plus>
            <c:minus>
              <c:numRef>
                <c:f>'Nrf2'!$H$120:$H$121</c:f>
                <c:numCache>
                  <c:formatCode>General</c:formatCode>
                  <c:ptCount val="2"/>
                  <c:pt idx="0">
                    <c:v>0.0824719313179827</c:v>
                  </c:pt>
                  <c:pt idx="1">
                    <c:v>0.374276509787858</c:v>
                  </c:pt>
                </c:numCache>
              </c:numRef>
            </c:minus>
          </c:errBars>
          <c:cat>
            <c:strRef>
              <c:f>'Nrf2'!$E$114:$E$115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Nrf2'!$H$114:$H$115</c:f>
              <c:numCache>
                <c:formatCode>General</c:formatCode>
                <c:ptCount val="2"/>
                <c:pt idx="0">
                  <c:v>1.589138740908696</c:v>
                </c:pt>
                <c:pt idx="1">
                  <c:v>1.29204354869543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FAE-4584-9501-BF573665D3DE}"/>
            </c:ext>
          </c:extLst>
        </c:ser>
        <c:ser>
          <c:idx val="3"/>
          <c:order val="3"/>
          <c:tx>
            <c:strRef>
              <c:f>'Nrf2'!$I$113</c:f>
              <c:strCache>
                <c:ptCount val="1"/>
                <c:pt idx="0">
                  <c:v>PMA+DV2 MOI 5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rf2'!$I$120:$I$121</c:f>
                <c:numCache>
                  <c:formatCode>General</c:formatCode>
                  <c:ptCount val="2"/>
                  <c:pt idx="0">
                    <c:v>0.15414389264318</c:v>
                  </c:pt>
                  <c:pt idx="1">
                    <c:v>0.104081764112365</c:v>
                  </c:pt>
                </c:numCache>
              </c:numRef>
            </c:plus>
            <c:minus>
              <c:numRef>
                <c:f>'Nrf2'!$I$120:$I$121</c:f>
                <c:numCache>
                  <c:formatCode>General</c:formatCode>
                  <c:ptCount val="2"/>
                  <c:pt idx="0">
                    <c:v>0.15414389264318</c:v>
                  </c:pt>
                  <c:pt idx="1">
                    <c:v>0.104081764112365</c:v>
                  </c:pt>
                </c:numCache>
              </c:numRef>
            </c:minus>
          </c:errBars>
          <c:cat>
            <c:strRef>
              <c:f>'Nrf2'!$E$114:$E$115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Nrf2'!$I$114:$I$115</c:f>
              <c:numCache>
                <c:formatCode>General</c:formatCode>
                <c:ptCount val="2"/>
                <c:pt idx="0">
                  <c:v>1.567921850335524</c:v>
                </c:pt>
                <c:pt idx="1">
                  <c:v>1.0905176280604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FAE-4584-9501-BF573665D3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21356472"/>
        <c:axId val="1921159240"/>
      </c:barChart>
      <c:catAx>
        <c:axId val="19213564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21159240"/>
        <c:crosses val="autoZero"/>
        <c:auto val="1"/>
        <c:lblAlgn val="ctr"/>
        <c:lblOffset val="100"/>
        <c:noMultiLvlLbl val="0"/>
      </c:catAx>
      <c:valAx>
        <c:axId val="19211592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b="0" i="0">
                    <a:latin typeface="Times New Roman"/>
                    <a:cs typeface="Times New Roman"/>
                  </a:rPr>
                  <a:t>Relative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213564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000">
                <a:latin typeface="Times New Roman"/>
                <a:cs typeface="Times New Roman"/>
              </a:defRPr>
            </a:pPr>
            <a:r>
              <a:rPr lang="en-US" sz="1000" dirty="0">
                <a:latin typeface="Times New Roman"/>
                <a:cs typeface="Times New Roman"/>
              </a:rPr>
              <a:t>KEAP1</a:t>
            </a:r>
          </a:p>
        </c:rich>
      </c:tx>
      <c:layout>
        <c:manualLayout>
          <c:xMode val="edge"/>
          <c:yMode val="edge"/>
          <c:x val="0.371476111111111"/>
          <c:y val="0.0343818342151675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330217222222222"/>
          <c:y val="0.0727954144620811"/>
          <c:w val="0.578060555555556"/>
          <c:h val="0.8076525573192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Keap1!$F$112</c:f>
              <c:strCache>
                <c:ptCount val="1"/>
                <c:pt idx="0">
                  <c:v>MOCK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Keap1!$F$119:$F$120</c:f>
                <c:numCache>
                  <c:formatCode>General</c:formatCode>
                  <c:ptCount val="2"/>
                  <c:pt idx="0">
                    <c:v>0.128850485527572</c:v>
                  </c:pt>
                  <c:pt idx="1">
                    <c:v>0.128850485527572</c:v>
                  </c:pt>
                </c:numCache>
              </c:numRef>
            </c:plus>
            <c:minus>
              <c:numRef>
                <c:f>Keap1!$F$119:$F$120</c:f>
                <c:numCache>
                  <c:formatCode>General</c:formatCode>
                  <c:ptCount val="2"/>
                  <c:pt idx="0">
                    <c:v>0.128850485527572</c:v>
                  </c:pt>
                  <c:pt idx="1">
                    <c:v>0.128850485527572</c:v>
                  </c:pt>
                </c:numCache>
              </c:numRef>
            </c:minus>
          </c:errBars>
          <c:cat>
            <c:strRef>
              <c:f>Keap1!$E$113:$E$114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Keap1!$F$113:$F$114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D43-49E2-8BE1-BACF40511FC8}"/>
            </c:ext>
          </c:extLst>
        </c:ser>
        <c:ser>
          <c:idx val="1"/>
          <c:order val="1"/>
          <c:tx>
            <c:strRef>
              <c:f>Keap1!$G$112</c:f>
              <c:strCache>
                <c:ptCount val="1"/>
                <c:pt idx="0">
                  <c:v>PMA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Keap1!$G$119:$G$120</c:f>
                <c:numCache>
                  <c:formatCode>General</c:formatCode>
                  <c:ptCount val="2"/>
                  <c:pt idx="0">
                    <c:v>0.0211772448230921</c:v>
                  </c:pt>
                  <c:pt idx="1">
                    <c:v>0.105464142110296</c:v>
                  </c:pt>
                </c:numCache>
              </c:numRef>
            </c:plus>
            <c:minus>
              <c:numRef>
                <c:f>Keap1!$G$119:$G$120</c:f>
                <c:numCache>
                  <c:formatCode>General</c:formatCode>
                  <c:ptCount val="2"/>
                  <c:pt idx="0">
                    <c:v>0.0211772448230921</c:v>
                  </c:pt>
                  <c:pt idx="1">
                    <c:v>0.105464142110296</c:v>
                  </c:pt>
                </c:numCache>
              </c:numRef>
            </c:minus>
          </c:errBars>
          <c:cat>
            <c:strRef>
              <c:f>Keap1!$E$113:$E$114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Keap1!$G$113:$G$114</c:f>
              <c:numCache>
                <c:formatCode>General</c:formatCode>
                <c:ptCount val="2"/>
                <c:pt idx="0">
                  <c:v>0.520270489712152</c:v>
                </c:pt>
                <c:pt idx="1">
                  <c:v>0.6752018107329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D43-49E2-8BE1-BACF40511FC8}"/>
            </c:ext>
          </c:extLst>
        </c:ser>
        <c:ser>
          <c:idx val="2"/>
          <c:order val="2"/>
          <c:tx>
            <c:strRef>
              <c:f>Keap1!$H$112</c:f>
              <c:strCache>
                <c:ptCount val="1"/>
                <c:pt idx="0">
                  <c:v>PMA+DV2 MOI 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Keap1!$H$119:$H$120</c:f>
                <c:numCache>
                  <c:formatCode>General</c:formatCode>
                  <c:ptCount val="2"/>
                  <c:pt idx="0">
                    <c:v>0.0506849814968432</c:v>
                  </c:pt>
                  <c:pt idx="1">
                    <c:v>0.165098709624647</c:v>
                  </c:pt>
                </c:numCache>
              </c:numRef>
            </c:plus>
            <c:minus>
              <c:numRef>
                <c:f>Keap1!$H$119:$H$120</c:f>
                <c:numCache>
                  <c:formatCode>General</c:formatCode>
                  <c:ptCount val="2"/>
                  <c:pt idx="0">
                    <c:v>0.0506849814968432</c:v>
                  </c:pt>
                  <c:pt idx="1">
                    <c:v>0.165098709624647</c:v>
                  </c:pt>
                </c:numCache>
              </c:numRef>
            </c:minus>
          </c:errBars>
          <c:cat>
            <c:strRef>
              <c:f>Keap1!$E$113:$E$114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Keap1!$H$113:$H$114</c:f>
              <c:numCache>
                <c:formatCode>General</c:formatCode>
                <c:ptCount val="2"/>
                <c:pt idx="0">
                  <c:v>0.651573382470247</c:v>
                </c:pt>
                <c:pt idx="1">
                  <c:v>0.7232544730907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D43-49E2-8BE1-BACF40511FC8}"/>
            </c:ext>
          </c:extLst>
        </c:ser>
        <c:ser>
          <c:idx val="3"/>
          <c:order val="3"/>
          <c:tx>
            <c:strRef>
              <c:f>Keap1!$I$112</c:f>
              <c:strCache>
                <c:ptCount val="1"/>
                <c:pt idx="0">
                  <c:v>PMA+DV2 MOI 5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Keap1!$I$119:$I$120</c:f>
                <c:numCache>
                  <c:formatCode>General</c:formatCode>
                  <c:ptCount val="2"/>
                  <c:pt idx="0">
                    <c:v>0.0490696555093844</c:v>
                  </c:pt>
                  <c:pt idx="1">
                    <c:v>0.0746049108733177</c:v>
                  </c:pt>
                </c:numCache>
              </c:numRef>
            </c:plus>
            <c:minus>
              <c:numRef>
                <c:f>Keap1!$I$119:$I$120</c:f>
                <c:numCache>
                  <c:formatCode>General</c:formatCode>
                  <c:ptCount val="2"/>
                  <c:pt idx="0">
                    <c:v>0.0490696555093844</c:v>
                  </c:pt>
                  <c:pt idx="1">
                    <c:v>0.0746049108733177</c:v>
                  </c:pt>
                </c:numCache>
              </c:numRef>
            </c:minus>
          </c:errBars>
          <c:cat>
            <c:strRef>
              <c:f>Keap1!$E$113:$E$114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Keap1!$I$113:$I$114</c:f>
              <c:numCache>
                <c:formatCode>General</c:formatCode>
                <c:ptCount val="2"/>
                <c:pt idx="0">
                  <c:v>0.613872559147587</c:v>
                </c:pt>
                <c:pt idx="1">
                  <c:v>0.6357052884153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1D43-49E2-8BE1-BACF40511F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22005928"/>
        <c:axId val="1922000600"/>
      </c:barChart>
      <c:catAx>
        <c:axId val="19220059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22000600"/>
        <c:crosses val="autoZero"/>
        <c:auto val="1"/>
        <c:lblAlgn val="ctr"/>
        <c:lblOffset val="100"/>
        <c:noMultiLvlLbl val="0"/>
      </c:catAx>
      <c:valAx>
        <c:axId val="19220006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b="0">
                    <a:latin typeface="Times New Roman"/>
                    <a:cs typeface="Times New Roman"/>
                  </a:rPr>
                  <a:t>Relative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220059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4773690879327"/>
          <c:y val="0.214524021638066"/>
          <c:w val="0.51383936062405"/>
          <c:h val="0.5655174793421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0!$L$8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6350" cmpd="sng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0!$O$8:$O$9</c:f>
                <c:numCache>
                  <c:formatCode>General</c:formatCode>
                  <c:ptCount val="2"/>
                  <c:pt idx="0">
                    <c:v>0.0989949493661165</c:v>
                  </c:pt>
                  <c:pt idx="1">
                    <c:v>0.0707106781186551</c:v>
                  </c:pt>
                </c:numCache>
              </c:numRef>
            </c:plus>
            <c:minus>
              <c:numRef>
                <c:f>Sheet0!$O$8:$O$9</c:f>
                <c:numCache>
                  <c:formatCode>General</c:formatCode>
                  <c:ptCount val="2"/>
                  <c:pt idx="0">
                    <c:v>0.0989949493661165</c:v>
                  </c:pt>
                  <c:pt idx="1">
                    <c:v>0.07071067811865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0!$M$7:$N$7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Sheet0!$M$8:$N$8</c:f>
              <c:numCache>
                <c:formatCode>General</c:formatCode>
                <c:ptCount val="2"/>
                <c:pt idx="0">
                  <c:v>4.970000000000001</c:v>
                </c:pt>
                <c:pt idx="1">
                  <c:v>64.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4D8-DA4C-90FB-E60D31EBEDC9}"/>
            </c:ext>
          </c:extLst>
        </c:ser>
        <c:ser>
          <c:idx val="1"/>
          <c:order val="1"/>
          <c:tx>
            <c:strRef>
              <c:f>Sheet0!$L$9</c:f>
              <c:strCache>
                <c:ptCount val="1"/>
                <c:pt idx="0">
                  <c:v>Sodium Butyrat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0!$P$8:$P$9</c:f>
                <c:numCache>
                  <c:formatCode>General</c:formatCode>
                  <c:ptCount val="2"/>
                  <c:pt idx="0">
                    <c:v>2.192031021678298</c:v>
                  </c:pt>
                  <c:pt idx="1">
                    <c:v>3.323401871576773</c:v>
                  </c:pt>
                </c:numCache>
              </c:numRef>
            </c:plus>
            <c:minus>
              <c:numRef>
                <c:f>Sheet0!$P$8:$P$9</c:f>
                <c:numCache>
                  <c:formatCode>General</c:formatCode>
                  <c:ptCount val="2"/>
                  <c:pt idx="0">
                    <c:v>2.192031021678298</c:v>
                  </c:pt>
                  <c:pt idx="1">
                    <c:v>3.3234018715767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0!$M$7:$N$7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Sheet0!$M$9:$N$9</c:f>
              <c:numCache>
                <c:formatCode>General</c:formatCode>
                <c:ptCount val="2"/>
                <c:pt idx="0">
                  <c:v>4.819999999999998</c:v>
                </c:pt>
                <c:pt idx="1">
                  <c:v>29.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4D8-DA4C-90FB-E60D31EBED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13184280"/>
        <c:axId val="1912771496"/>
      </c:barChart>
      <c:catAx>
        <c:axId val="1913184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12771496"/>
        <c:crosses val="autoZero"/>
        <c:auto val="1"/>
        <c:lblAlgn val="ctr"/>
        <c:lblOffset val="100"/>
        <c:noMultiLvlLbl val="0"/>
      </c:catAx>
      <c:valAx>
        <c:axId val="19127714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0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DENV2 Antigen Positive </a:t>
                </a:r>
                <a:r>
                  <a:rPr lang="en-IN" sz="1000" dirty="0" smtClean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s</a:t>
                </a:r>
                <a:endParaRPr lang="en-IN" sz="100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215281739230584"/>
              <c:y val="0.17722966824543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913184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665803075902199"/>
          <c:y val="0.101459025593565"/>
          <c:w val="0.226147635308292"/>
          <c:h val="0.17591406809393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 dirty="0">
                <a:latin typeface="Times New Roman"/>
                <a:cs typeface="Times New Roman"/>
              </a:rPr>
              <a:t>AK5</a:t>
            </a:r>
          </a:p>
        </c:rich>
      </c:tx>
      <c:layout>
        <c:manualLayout>
          <c:xMode val="edge"/>
          <c:yMode val="edge"/>
          <c:x val="0.404951666666667"/>
          <c:y val="0.151190476190476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K5'!$F$110</c:f>
              <c:strCache>
                <c:ptCount val="1"/>
                <c:pt idx="0">
                  <c:v>Untreated Mock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AK5'!$F$117:$F$118</c:f>
                <c:numCache>
                  <c:formatCode>General</c:formatCode>
                  <c:ptCount val="2"/>
                  <c:pt idx="0">
                    <c:v>0.409459843194435</c:v>
                  </c:pt>
                  <c:pt idx="1">
                    <c:v>0.409459843194435</c:v>
                  </c:pt>
                </c:numCache>
              </c:numRef>
            </c:plus>
            <c:minus>
              <c:numRef>
                <c:f>'AK5'!$F$117:$F$118</c:f>
                <c:numCache>
                  <c:formatCode>General</c:formatCode>
                  <c:ptCount val="2"/>
                  <c:pt idx="0">
                    <c:v>0.409459843194435</c:v>
                  </c:pt>
                  <c:pt idx="1">
                    <c:v>0.409459843194435</c:v>
                  </c:pt>
                </c:numCache>
              </c:numRef>
            </c:minus>
          </c:errBars>
          <c:cat>
            <c:strRef>
              <c:f>'AK5'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AK5'!$F$111:$F$112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D8E-4712-86AF-1426D8908811}"/>
            </c:ext>
          </c:extLst>
        </c:ser>
        <c:ser>
          <c:idx val="1"/>
          <c:order val="1"/>
          <c:tx>
            <c:strRef>
              <c:f>'AK5'!$G$110</c:f>
              <c:strCache>
                <c:ptCount val="1"/>
                <c:pt idx="0">
                  <c:v>PM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5D8E-4712-86AF-1426D8908811}"/>
              </c:ext>
            </c:extLst>
          </c:dPt>
          <c:errBars>
            <c:errBarType val="both"/>
            <c:errValType val="cust"/>
            <c:noEndCap val="0"/>
            <c:plus>
              <c:numRef>
                <c:f>'AK5'!$G$117:$G$118</c:f>
                <c:numCache>
                  <c:formatCode>General</c:formatCode>
                  <c:ptCount val="2"/>
                  <c:pt idx="0">
                    <c:v>0.330573129312222</c:v>
                  </c:pt>
                  <c:pt idx="1">
                    <c:v>1.79743389985615</c:v>
                  </c:pt>
                </c:numCache>
              </c:numRef>
            </c:plus>
            <c:minus>
              <c:numRef>
                <c:f>'AK5'!$G$117:$G$118</c:f>
                <c:numCache>
                  <c:formatCode>General</c:formatCode>
                  <c:ptCount val="2"/>
                  <c:pt idx="0">
                    <c:v>0.330573129312222</c:v>
                  </c:pt>
                  <c:pt idx="1">
                    <c:v>1.79743389985615</c:v>
                  </c:pt>
                </c:numCache>
              </c:numRef>
            </c:minus>
          </c:errBars>
          <c:cat>
            <c:strRef>
              <c:f>'AK5'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AK5'!$G$111:$G$112</c:f>
              <c:numCache>
                <c:formatCode>General</c:formatCode>
                <c:ptCount val="2"/>
                <c:pt idx="0">
                  <c:v>0.775259280782295</c:v>
                </c:pt>
                <c:pt idx="1">
                  <c:v>5.47012266472584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D8E-4712-86AF-1426D8908811}"/>
            </c:ext>
          </c:extLst>
        </c:ser>
        <c:ser>
          <c:idx val="2"/>
          <c:order val="2"/>
          <c:tx>
            <c:strRef>
              <c:f>'AK5'!$H$110</c:f>
              <c:strCache>
                <c:ptCount val="1"/>
                <c:pt idx="0">
                  <c:v>PMA+DENV (MOI 1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AK5'!$H$117:$H$118</c:f>
                <c:numCache>
                  <c:formatCode>General</c:formatCode>
                  <c:ptCount val="2"/>
                  <c:pt idx="0">
                    <c:v>0.617841495367389</c:v>
                  </c:pt>
                  <c:pt idx="1">
                    <c:v>7.022586547499335</c:v>
                  </c:pt>
                </c:numCache>
              </c:numRef>
            </c:plus>
            <c:minus>
              <c:numRef>
                <c:f>'AK5'!$H$117:$H$118</c:f>
                <c:numCache>
                  <c:formatCode>General</c:formatCode>
                  <c:ptCount val="2"/>
                  <c:pt idx="0">
                    <c:v>0.617841495367389</c:v>
                  </c:pt>
                  <c:pt idx="1">
                    <c:v>7.022586547499335</c:v>
                  </c:pt>
                </c:numCache>
              </c:numRef>
            </c:minus>
          </c:errBars>
          <c:cat>
            <c:strRef>
              <c:f>'AK5'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AK5'!$H$111:$H$112</c:f>
              <c:numCache>
                <c:formatCode>General</c:formatCode>
                <c:ptCount val="2"/>
                <c:pt idx="0">
                  <c:v>0.714540561812749</c:v>
                </c:pt>
                <c:pt idx="1">
                  <c:v>44.534280307035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5D8E-4712-86AF-1426D8908811}"/>
            </c:ext>
          </c:extLst>
        </c:ser>
        <c:ser>
          <c:idx val="3"/>
          <c:order val="3"/>
          <c:tx>
            <c:strRef>
              <c:f>'AK5'!$I$110</c:f>
              <c:strCache>
                <c:ptCount val="1"/>
                <c:pt idx="0">
                  <c:v>PMA+DENV (MOI 5)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AK5'!$I$117:$I$118</c:f>
                <c:numCache>
                  <c:formatCode>General</c:formatCode>
                  <c:ptCount val="2"/>
                  <c:pt idx="0">
                    <c:v>1.004290514313386</c:v>
                  </c:pt>
                  <c:pt idx="1">
                    <c:v>8.548871734498331</c:v>
                  </c:pt>
                </c:numCache>
              </c:numRef>
            </c:plus>
            <c:minus>
              <c:numRef>
                <c:f>'AK5'!$I$117:$I$118</c:f>
                <c:numCache>
                  <c:formatCode>General</c:formatCode>
                  <c:ptCount val="2"/>
                  <c:pt idx="0">
                    <c:v>1.004290514313386</c:v>
                  </c:pt>
                  <c:pt idx="1">
                    <c:v>8.548871734498331</c:v>
                  </c:pt>
                </c:numCache>
              </c:numRef>
            </c:minus>
          </c:errBars>
          <c:cat>
            <c:strRef>
              <c:f>'AK5'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AK5'!$I$111:$I$112</c:f>
              <c:numCache>
                <c:formatCode>General</c:formatCode>
                <c:ptCount val="2"/>
                <c:pt idx="0">
                  <c:v>1.586302803564325</c:v>
                </c:pt>
                <c:pt idx="1">
                  <c:v>52.36223485003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5D8E-4712-86AF-1426D89088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7683640"/>
        <c:axId val="1937687240"/>
      </c:barChart>
      <c:catAx>
        <c:axId val="19376836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solidFill>
                  <a:schemeClr val="tx1"/>
                </a:solidFill>
                <a:latin typeface="Times New Roman"/>
                <a:cs typeface="Times New Roman"/>
              </a:defRPr>
            </a:pPr>
            <a:endParaRPr lang="en-US"/>
          </a:p>
        </c:txPr>
        <c:crossAx val="1937687240"/>
        <c:crosses val="autoZero"/>
        <c:auto val="1"/>
        <c:lblAlgn val="ctr"/>
        <c:lblOffset val="100"/>
        <c:noMultiLvlLbl val="0"/>
      </c:catAx>
      <c:valAx>
        <c:axId val="19376872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b="0">
                    <a:latin typeface="Times New Roman"/>
                    <a:cs typeface="Times New Roman"/>
                  </a:rPr>
                  <a:t>Relative fold change</a:t>
                </a:r>
                <a:r>
                  <a:rPr lang="en-US" b="0" baseline="0">
                    <a:latin typeface="Times New Roman"/>
                    <a:cs typeface="Times New Roman"/>
                  </a:rPr>
                  <a:t> </a:t>
                </a:r>
                <a:endParaRPr lang="en-US" b="0">
                  <a:latin typeface="Times New Roman"/>
                  <a:cs typeface="Times New Roman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376836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>
                <a:latin typeface="Times New Roman"/>
                <a:cs typeface="Times New Roman"/>
              </a:rPr>
              <a:t>CPT1A</a:t>
            </a:r>
          </a:p>
        </c:rich>
      </c:tx>
      <c:layout>
        <c:manualLayout>
          <c:xMode val="edge"/>
          <c:yMode val="edge"/>
          <c:x val="0.403775387071168"/>
          <c:y val="0.1298270621751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PT1A!$F$110</c:f>
              <c:strCache>
                <c:ptCount val="1"/>
                <c:pt idx="0">
                  <c:v>MOCK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CPT1A!$F$117:$F$118</c:f>
                <c:numCache>
                  <c:formatCode>General</c:formatCode>
                  <c:ptCount val="2"/>
                  <c:pt idx="0">
                    <c:v>0.141820506229649</c:v>
                  </c:pt>
                  <c:pt idx="1">
                    <c:v>0.141820506229649</c:v>
                  </c:pt>
                </c:numCache>
              </c:numRef>
            </c:plus>
            <c:minus>
              <c:numRef>
                <c:f>CPT1A!$F$117:$F$118</c:f>
                <c:numCache>
                  <c:formatCode>General</c:formatCode>
                  <c:ptCount val="2"/>
                  <c:pt idx="0">
                    <c:v>0.141820506229649</c:v>
                  </c:pt>
                  <c:pt idx="1">
                    <c:v>0.141820506229649</c:v>
                  </c:pt>
                </c:numCache>
              </c:numRef>
            </c:minus>
          </c:errBars>
          <c:cat>
            <c:strRef>
              <c:f>CPT1A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CPT1A!$F$111:$F$112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288-4EFA-BFA9-831DB8645629}"/>
            </c:ext>
          </c:extLst>
        </c:ser>
        <c:ser>
          <c:idx val="1"/>
          <c:order val="1"/>
          <c:tx>
            <c:strRef>
              <c:f>CPT1A!$G$110</c:f>
              <c:strCache>
                <c:ptCount val="1"/>
                <c:pt idx="0">
                  <c:v>PM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PT1A!$G$117:$G$118</c:f>
                <c:numCache>
                  <c:formatCode>General</c:formatCode>
                  <c:ptCount val="2"/>
                  <c:pt idx="0">
                    <c:v>0.190243665821394</c:v>
                  </c:pt>
                  <c:pt idx="1">
                    <c:v>2.857809140088424</c:v>
                  </c:pt>
                </c:numCache>
              </c:numRef>
            </c:plus>
            <c:minus>
              <c:numRef>
                <c:f>CPT1A!$G$117:$G$118</c:f>
                <c:numCache>
                  <c:formatCode>General</c:formatCode>
                  <c:ptCount val="2"/>
                  <c:pt idx="0">
                    <c:v>0.190243665821394</c:v>
                  </c:pt>
                  <c:pt idx="1">
                    <c:v>2.857809140088424</c:v>
                  </c:pt>
                </c:numCache>
              </c:numRef>
            </c:minus>
          </c:errBars>
          <c:cat>
            <c:strRef>
              <c:f>CPT1A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CPT1A!$G$111:$G$112</c:f>
              <c:numCache>
                <c:formatCode>General</c:formatCode>
                <c:ptCount val="2"/>
                <c:pt idx="0">
                  <c:v>0.869408345342514</c:v>
                </c:pt>
                <c:pt idx="1">
                  <c:v>6.4975159184712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288-4EFA-BFA9-831DB8645629}"/>
            </c:ext>
          </c:extLst>
        </c:ser>
        <c:ser>
          <c:idx val="2"/>
          <c:order val="2"/>
          <c:tx>
            <c:strRef>
              <c:f>CPT1A!$H$110</c:f>
              <c:strCache>
                <c:ptCount val="1"/>
                <c:pt idx="0">
                  <c:v>PMA+DV2 MOI 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PT1A!$H$117:$H$118</c:f>
                <c:numCache>
                  <c:formatCode>General</c:formatCode>
                  <c:ptCount val="2"/>
                  <c:pt idx="0">
                    <c:v>0.402098187643446</c:v>
                  </c:pt>
                  <c:pt idx="1">
                    <c:v>7.174219637323461</c:v>
                  </c:pt>
                </c:numCache>
              </c:numRef>
            </c:plus>
            <c:minus>
              <c:numRef>
                <c:f>CPT1A!$H$117:$H$118</c:f>
                <c:numCache>
                  <c:formatCode>General</c:formatCode>
                  <c:ptCount val="2"/>
                  <c:pt idx="0">
                    <c:v>0.402098187643446</c:v>
                  </c:pt>
                  <c:pt idx="1">
                    <c:v>7.174219637323461</c:v>
                  </c:pt>
                </c:numCache>
              </c:numRef>
            </c:minus>
          </c:errBars>
          <c:cat>
            <c:strRef>
              <c:f>CPT1A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CPT1A!$H$111:$H$112</c:f>
              <c:numCache>
                <c:formatCode>General</c:formatCode>
                <c:ptCount val="2"/>
                <c:pt idx="0">
                  <c:v>1.453417210739736</c:v>
                </c:pt>
                <c:pt idx="1">
                  <c:v>66.107643799821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288-4EFA-BFA9-831DB8645629}"/>
            </c:ext>
          </c:extLst>
        </c:ser>
        <c:ser>
          <c:idx val="3"/>
          <c:order val="3"/>
          <c:tx>
            <c:strRef>
              <c:f>CPT1A!$I$110</c:f>
              <c:strCache>
                <c:ptCount val="1"/>
                <c:pt idx="0">
                  <c:v>PMA+DV2 MOI 5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PT1A!$I$117:$I$118</c:f>
                <c:numCache>
                  <c:formatCode>General</c:formatCode>
                  <c:ptCount val="2"/>
                  <c:pt idx="0">
                    <c:v>1.679341304321951</c:v>
                  </c:pt>
                  <c:pt idx="1">
                    <c:v>7.603977434983976</c:v>
                  </c:pt>
                </c:numCache>
              </c:numRef>
            </c:plus>
            <c:minus>
              <c:numRef>
                <c:f>CPT1A!$I$117:$I$118</c:f>
                <c:numCache>
                  <c:formatCode>General</c:formatCode>
                  <c:ptCount val="2"/>
                  <c:pt idx="0">
                    <c:v>1.679341304321951</c:v>
                  </c:pt>
                  <c:pt idx="1">
                    <c:v>7.603977434983976</c:v>
                  </c:pt>
                </c:numCache>
              </c:numRef>
            </c:minus>
          </c:errBars>
          <c:cat>
            <c:strRef>
              <c:f>CPT1A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CPT1A!$I$111:$I$112</c:f>
              <c:numCache>
                <c:formatCode>General</c:formatCode>
                <c:ptCount val="2"/>
                <c:pt idx="0">
                  <c:v>2.11275667792718</c:v>
                </c:pt>
                <c:pt idx="1">
                  <c:v>79.054933616140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8288-4EFA-BFA9-831DB86456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7351608"/>
        <c:axId val="1937362584"/>
      </c:barChart>
      <c:catAx>
        <c:axId val="19373516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solidFill>
                  <a:srgbClr val="000000"/>
                </a:solidFill>
                <a:latin typeface="Times New Roman"/>
                <a:cs typeface="Times New Roman"/>
              </a:defRPr>
            </a:pPr>
            <a:endParaRPr lang="en-US"/>
          </a:p>
        </c:txPr>
        <c:crossAx val="1937362584"/>
        <c:crosses val="autoZero"/>
        <c:auto val="1"/>
        <c:lblAlgn val="ctr"/>
        <c:lblOffset val="100"/>
        <c:noMultiLvlLbl val="0"/>
      </c:catAx>
      <c:valAx>
        <c:axId val="19373625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Times New Roman"/>
                    <a:cs typeface="Times New Roman"/>
                  </a:defRPr>
                </a:pPr>
                <a:r>
                  <a:rPr lang="en-US" b="0">
                    <a:latin typeface="Times New Roman"/>
                    <a:cs typeface="Times New Roman"/>
                  </a:rPr>
                  <a:t>Relative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solidFill>
                  <a:srgbClr val="000000"/>
                </a:solidFill>
                <a:latin typeface="Times New Roman"/>
                <a:cs typeface="Times New Roman"/>
              </a:defRPr>
            </a:pPr>
            <a:endParaRPr lang="en-US"/>
          </a:p>
        </c:txPr>
        <c:crossAx val="19373516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>
                <a:solidFill>
                  <a:srgbClr val="000000"/>
                </a:solidFill>
                <a:latin typeface="Times New Roman"/>
                <a:cs typeface="Times New Roman"/>
              </a:rPr>
              <a:t>DSC3</a:t>
            </a:r>
          </a:p>
        </c:rich>
      </c:tx>
      <c:layout>
        <c:manualLayout>
          <c:xMode val="edge"/>
          <c:yMode val="edge"/>
          <c:x val="0.398736111111111"/>
          <c:y val="0.148390931372549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SC3'!$F$110</c:f>
              <c:strCache>
                <c:ptCount val="1"/>
                <c:pt idx="0">
                  <c:v>MOCK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SC3'!$F$117:$F$118</c:f>
                <c:numCache>
                  <c:formatCode>General</c:formatCode>
                  <c:ptCount val="2"/>
                  <c:pt idx="0">
                    <c:v>0.21313770270975</c:v>
                  </c:pt>
                  <c:pt idx="1">
                    <c:v>0.21313770270975</c:v>
                  </c:pt>
                </c:numCache>
              </c:numRef>
            </c:plus>
            <c:minus>
              <c:numRef>
                <c:f>'DSC3'!$F$117:$F$118</c:f>
                <c:numCache>
                  <c:formatCode>General</c:formatCode>
                  <c:ptCount val="2"/>
                  <c:pt idx="0">
                    <c:v>0.21313770270975</c:v>
                  </c:pt>
                  <c:pt idx="1">
                    <c:v>0.21313770270975</c:v>
                  </c:pt>
                </c:numCache>
              </c:numRef>
            </c:minus>
          </c:errBars>
          <c:cat>
            <c:strRef>
              <c:f>'DSC3'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DSC3'!$F$111:$F$112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8E9-4DB4-9B41-796EC51F1705}"/>
            </c:ext>
          </c:extLst>
        </c:ser>
        <c:ser>
          <c:idx val="1"/>
          <c:order val="1"/>
          <c:tx>
            <c:strRef>
              <c:f>'DSC3'!$G$110</c:f>
              <c:strCache>
                <c:ptCount val="1"/>
                <c:pt idx="0">
                  <c:v>PM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SC3'!$G$117:$G$118</c:f>
                <c:numCache>
                  <c:formatCode>General</c:formatCode>
                  <c:ptCount val="2"/>
                  <c:pt idx="0">
                    <c:v>0.0777390130461385</c:v>
                  </c:pt>
                  <c:pt idx="1">
                    <c:v>0.134225450340777</c:v>
                  </c:pt>
                </c:numCache>
              </c:numRef>
            </c:plus>
            <c:minus>
              <c:numRef>
                <c:f>'DSC3'!$G$117:$G$118</c:f>
                <c:numCache>
                  <c:formatCode>General</c:formatCode>
                  <c:ptCount val="2"/>
                  <c:pt idx="0">
                    <c:v>0.0777390130461385</c:v>
                  </c:pt>
                  <c:pt idx="1">
                    <c:v>0.134225450340777</c:v>
                  </c:pt>
                </c:numCache>
              </c:numRef>
            </c:minus>
          </c:errBars>
          <c:cat>
            <c:strRef>
              <c:f>'DSC3'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DSC3'!$G$111:$G$112</c:f>
              <c:numCache>
                <c:formatCode>General</c:formatCode>
                <c:ptCount val="2"/>
                <c:pt idx="0">
                  <c:v>0.353624038999345</c:v>
                </c:pt>
                <c:pt idx="1">
                  <c:v>0.820491219368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8E9-4DB4-9B41-796EC51F1705}"/>
            </c:ext>
          </c:extLst>
        </c:ser>
        <c:ser>
          <c:idx val="2"/>
          <c:order val="2"/>
          <c:tx>
            <c:strRef>
              <c:f>'DSC3'!$H$110</c:f>
              <c:strCache>
                <c:ptCount val="1"/>
                <c:pt idx="0">
                  <c:v>PMA+DV2 MOI 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SC3'!$H$117:$H$118</c:f>
                <c:numCache>
                  <c:formatCode>General</c:formatCode>
                  <c:ptCount val="2"/>
                  <c:pt idx="0">
                    <c:v>0.150771388879892</c:v>
                  </c:pt>
                  <c:pt idx="1">
                    <c:v>0.686322062062071</c:v>
                  </c:pt>
                </c:numCache>
              </c:numRef>
            </c:plus>
            <c:minus>
              <c:numRef>
                <c:f>'DSC3'!$H$117:$H$118</c:f>
                <c:numCache>
                  <c:formatCode>General</c:formatCode>
                  <c:ptCount val="2"/>
                  <c:pt idx="0">
                    <c:v>0.150771388879892</c:v>
                  </c:pt>
                  <c:pt idx="1">
                    <c:v>0.686322062062071</c:v>
                  </c:pt>
                </c:numCache>
              </c:numRef>
            </c:minus>
          </c:errBars>
          <c:cat>
            <c:strRef>
              <c:f>'DSC3'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DSC3'!$H$111:$H$112</c:f>
              <c:numCache>
                <c:formatCode>General</c:formatCode>
                <c:ptCount val="2"/>
                <c:pt idx="0">
                  <c:v>0.42699743281703</c:v>
                </c:pt>
                <c:pt idx="1">
                  <c:v>4.659825417151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8E9-4DB4-9B41-796EC51F1705}"/>
            </c:ext>
          </c:extLst>
        </c:ser>
        <c:ser>
          <c:idx val="3"/>
          <c:order val="3"/>
          <c:tx>
            <c:strRef>
              <c:f>'DSC3'!$I$110</c:f>
              <c:strCache>
                <c:ptCount val="1"/>
                <c:pt idx="0">
                  <c:v>PMA+DV2 MOI 5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SC3'!$I$117:$I$118</c:f>
                <c:numCache>
                  <c:formatCode>General</c:formatCode>
                  <c:ptCount val="2"/>
                  <c:pt idx="0">
                    <c:v>0.130067258448323</c:v>
                  </c:pt>
                  <c:pt idx="1">
                    <c:v>0.591994702994103</c:v>
                  </c:pt>
                </c:numCache>
              </c:numRef>
            </c:plus>
            <c:minus>
              <c:numRef>
                <c:f>'DSC3'!$I$117:$I$118</c:f>
                <c:numCache>
                  <c:formatCode>General</c:formatCode>
                  <c:ptCount val="2"/>
                  <c:pt idx="0">
                    <c:v>0.130067258448323</c:v>
                  </c:pt>
                  <c:pt idx="1">
                    <c:v>0.591994702994103</c:v>
                  </c:pt>
                </c:numCache>
              </c:numRef>
            </c:minus>
          </c:errBars>
          <c:cat>
            <c:strRef>
              <c:f>'DSC3'!$E$111:$E$112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DSC3'!$I$111:$I$112</c:f>
              <c:numCache>
                <c:formatCode>General</c:formatCode>
                <c:ptCount val="2"/>
                <c:pt idx="0">
                  <c:v>0.521172161936931</c:v>
                </c:pt>
                <c:pt idx="1">
                  <c:v>5.679460464216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8E9-4DB4-9B41-796EC51F17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7311928"/>
        <c:axId val="1936850152"/>
      </c:barChart>
      <c:catAx>
        <c:axId val="19373119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solidFill>
                  <a:srgbClr val="000000"/>
                </a:solidFill>
                <a:latin typeface="Times New Roman"/>
                <a:cs typeface="Times New Roman"/>
              </a:defRPr>
            </a:pPr>
            <a:endParaRPr lang="en-US"/>
          </a:p>
        </c:txPr>
        <c:crossAx val="1936850152"/>
        <c:crosses val="autoZero"/>
        <c:auto val="1"/>
        <c:lblAlgn val="ctr"/>
        <c:lblOffset val="100"/>
        <c:noMultiLvlLbl val="0"/>
      </c:catAx>
      <c:valAx>
        <c:axId val="19368501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b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Relative</a:t>
                </a:r>
                <a:r>
                  <a:rPr lang="en-US" b="0" baseline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fold change</a:t>
                </a:r>
                <a:endParaRPr lang="en-US" b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solidFill>
                  <a:srgbClr val="000000"/>
                </a:solidFill>
                <a:latin typeface="Times New Roman"/>
                <a:cs typeface="Times New Roman"/>
              </a:defRPr>
            </a:pPr>
            <a:endParaRPr lang="en-US"/>
          </a:p>
        </c:txPr>
        <c:crossAx val="19373119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9"/>
    </mc:Choice>
    <mc:Fallback>
      <c:style val="9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 dirty="0">
                <a:latin typeface="Times New Roman"/>
                <a:cs typeface="Times New Roman"/>
              </a:rPr>
              <a:t>HMOX2</a:t>
            </a:r>
          </a:p>
        </c:rich>
      </c:tx>
      <c:layout>
        <c:manualLayout>
          <c:xMode val="edge"/>
          <c:yMode val="edge"/>
          <c:x val="0.379646867098151"/>
          <c:y val="0.03488657741877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MOX2!$E$109</c:f>
              <c:strCache>
                <c:ptCount val="1"/>
                <c:pt idx="0">
                  <c:v>Mock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HMOX2!$M$110:$M$111</c:f>
                <c:numCache>
                  <c:formatCode>General</c:formatCode>
                  <c:ptCount val="2"/>
                  <c:pt idx="0">
                    <c:v>0.0293900512648491</c:v>
                  </c:pt>
                  <c:pt idx="1">
                    <c:v>0.0293900512648491</c:v>
                  </c:pt>
                </c:numCache>
              </c:numRef>
            </c:plus>
            <c:minus>
              <c:numRef>
                <c:f>HMOX2!$M$110:$M$111</c:f>
                <c:numCache>
                  <c:formatCode>General</c:formatCode>
                  <c:ptCount val="2"/>
                  <c:pt idx="0">
                    <c:v>0.0293900512648491</c:v>
                  </c:pt>
                  <c:pt idx="1">
                    <c:v>0.0293900512648491</c:v>
                  </c:pt>
                </c:numCache>
              </c:numRef>
            </c:minus>
          </c:errBars>
          <c:cat>
            <c:strRef>
              <c:f>HMOX2!$D$110:$D$111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HMOX2!$E$110:$E$111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B60-4CAC-AFB4-E01FD6C283F0}"/>
            </c:ext>
          </c:extLst>
        </c:ser>
        <c:ser>
          <c:idx val="1"/>
          <c:order val="1"/>
          <c:tx>
            <c:strRef>
              <c:f>HMOX2!$F$109</c:f>
              <c:strCache>
                <c:ptCount val="1"/>
                <c:pt idx="0">
                  <c:v>PMA</c:v>
                </c:pt>
              </c:strCache>
            </c:strRef>
          </c:tx>
          <c:spPr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MOX2!$N$110:$N$111</c:f>
                <c:numCache>
                  <c:formatCode>General</c:formatCode>
                  <c:ptCount val="2"/>
                  <c:pt idx="0">
                    <c:v>0.0600478284915686</c:v>
                  </c:pt>
                  <c:pt idx="1">
                    <c:v>0.0362674277753261</c:v>
                  </c:pt>
                </c:numCache>
              </c:numRef>
            </c:plus>
            <c:minus>
              <c:numRef>
                <c:f>HMOX2!$N$110:$N$111</c:f>
                <c:numCache>
                  <c:formatCode>General</c:formatCode>
                  <c:ptCount val="2"/>
                  <c:pt idx="0">
                    <c:v>0.0600478284915686</c:v>
                  </c:pt>
                  <c:pt idx="1">
                    <c:v>0.0362674277753261</c:v>
                  </c:pt>
                </c:numCache>
              </c:numRef>
            </c:minus>
          </c:errBars>
          <c:cat>
            <c:strRef>
              <c:f>HMOX2!$D$110:$D$111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HMOX2!$F$110:$F$111</c:f>
              <c:numCache>
                <c:formatCode>General</c:formatCode>
                <c:ptCount val="2"/>
                <c:pt idx="0">
                  <c:v>0.567193739087466</c:v>
                </c:pt>
                <c:pt idx="1">
                  <c:v>0.6559230541597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B60-4CAC-AFB4-E01FD6C283F0}"/>
            </c:ext>
          </c:extLst>
        </c:ser>
        <c:ser>
          <c:idx val="2"/>
          <c:order val="2"/>
          <c:tx>
            <c:strRef>
              <c:f>HMOX2!$G$109</c:f>
              <c:strCache>
                <c:ptCount val="1"/>
                <c:pt idx="0">
                  <c:v>PMA+DV2 MOI 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MOX2!$O$110:$O$111</c:f>
                <c:numCache>
                  <c:formatCode>General</c:formatCode>
                  <c:ptCount val="2"/>
                  <c:pt idx="0">
                    <c:v>0.266353900065625</c:v>
                  </c:pt>
                  <c:pt idx="1">
                    <c:v>1.279610223339238</c:v>
                  </c:pt>
                </c:numCache>
              </c:numRef>
            </c:plus>
            <c:minus>
              <c:numRef>
                <c:f>HMOX2!$O$110:$O$111</c:f>
                <c:numCache>
                  <c:formatCode>General</c:formatCode>
                  <c:ptCount val="2"/>
                  <c:pt idx="0">
                    <c:v>0.266353900065625</c:v>
                  </c:pt>
                  <c:pt idx="1">
                    <c:v>1.279610223339238</c:v>
                  </c:pt>
                </c:numCache>
              </c:numRef>
            </c:minus>
          </c:errBars>
          <c:cat>
            <c:strRef>
              <c:f>HMOX2!$D$110:$D$111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HMOX2!$G$110:$G$111</c:f>
              <c:numCache>
                <c:formatCode>General</c:formatCode>
                <c:ptCount val="2"/>
                <c:pt idx="0">
                  <c:v>1.509538907002088</c:v>
                </c:pt>
                <c:pt idx="1">
                  <c:v>6.9559642382337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B60-4CAC-AFB4-E01FD6C283F0}"/>
            </c:ext>
          </c:extLst>
        </c:ser>
        <c:ser>
          <c:idx val="3"/>
          <c:order val="3"/>
          <c:tx>
            <c:strRef>
              <c:f>HMOX2!$H$109</c:f>
              <c:strCache>
                <c:ptCount val="1"/>
                <c:pt idx="0">
                  <c:v>PMA+DV2 MOI 5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MOX2!$P$110:$P$111</c:f>
                <c:numCache>
                  <c:formatCode>General</c:formatCode>
                  <c:ptCount val="2"/>
                  <c:pt idx="0">
                    <c:v>0.475373538893402</c:v>
                  </c:pt>
                  <c:pt idx="1">
                    <c:v>3.869924966333702</c:v>
                  </c:pt>
                </c:numCache>
              </c:numRef>
            </c:plus>
            <c:minus>
              <c:numRef>
                <c:f>HMOX2!$P$110:$P$111</c:f>
                <c:numCache>
                  <c:formatCode>General</c:formatCode>
                  <c:ptCount val="2"/>
                  <c:pt idx="0">
                    <c:v>0.475373538893402</c:v>
                  </c:pt>
                  <c:pt idx="1">
                    <c:v>3.869924966333702</c:v>
                  </c:pt>
                </c:numCache>
              </c:numRef>
            </c:minus>
          </c:errBars>
          <c:cat>
            <c:strRef>
              <c:f>HMOX2!$D$110:$D$111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HMOX2!$H$110:$H$111</c:f>
              <c:numCache>
                <c:formatCode>General</c:formatCode>
                <c:ptCount val="2"/>
                <c:pt idx="0">
                  <c:v>2.628757821728756</c:v>
                </c:pt>
                <c:pt idx="1">
                  <c:v>11.7106662803963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1B60-4CAC-AFB4-E01FD6C283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7731288"/>
        <c:axId val="1937734664"/>
      </c:barChart>
      <c:catAx>
        <c:axId val="19377312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37734664"/>
        <c:crosses val="autoZero"/>
        <c:auto val="1"/>
        <c:lblAlgn val="ctr"/>
        <c:lblOffset val="100"/>
        <c:noMultiLvlLbl val="0"/>
      </c:catAx>
      <c:valAx>
        <c:axId val="19377346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/>
                </a:pPr>
                <a:r>
                  <a:rPr lang="en-US" sz="1000" b="0" dirty="0">
                    <a:latin typeface="Times New Roman"/>
                    <a:cs typeface="Times New Roman"/>
                  </a:rPr>
                  <a:t>Relative fold</a:t>
                </a:r>
                <a:r>
                  <a:rPr lang="en-US" sz="1000" b="0" baseline="0" dirty="0">
                    <a:latin typeface="Times New Roman"/>
                    <a:cs typeface="Times New Roman"/>
                  </a:rPr>
                  <a:t> change</a:t>
                </a:r>
                <a:endParaRPr lang="en-US" sz="1000" b="0" dirty="0">
                  <a:latin typeface="Times New Roman"/>
                  <a:cs typeface="Times New Roman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377312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9"/>
    </mc:Choice>
    <mc:Fallback>
      <c:style val="9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 dirty="0">
                <a:latin typeface="Times New Roman"/>
                <a:cs typeface="Times New Roman"/>
              </a:rPr>
              <a:t>NQO1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QO1'!$F$111</c:f>
              <c:strCache>
                <c:ptCount val="1"/>
                <c:pt idx="0">
                  <c:v>Mock</c:v>
                </c:pt>
              </c:strCache>
            </c:strRef>
          </c:tx>
          <c:spPr>
            <a:solidFill>
              <a:schemeClr val="tx1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QO1'!$N$112:$N$113</c:f>
                <c:numCache>
                  <c:formatCode>General</c:formatCode>
                  <c:ptCount val="2"/>
                  <c:pt idx="0">
                    <c:v>0.36797641472736</c:v>
                  </c:pt>
                  <c:pt idx="1">
                    <c:v>0.36797641472736</c:v>
                  </c:pt>
                </c:numCache>
              </c:numRef>
            </c:plus>
            <c:minus>
              <c:numRef>
                <c:f>'NQO1'!$N$112:$N$113</c:f>
                <c:numCache>
                  <c:formatCode>General</c:formatCode>
                  <c:ptCount val="2"/>
                  <c:pt idx="0">
                    <c:v>0.36797641472736</c:v>
                  </c:pt>
                  <c:pt idx="1">
                    <c:v>0.36797641472736</c:v>
                  </c:pt>
                </c:numCache>
              </c:numRef>
            </c:minus>
          </c:errBars>
          <c:cat>
            <c:strRef>
              <c:f>'NQO1'!$E$112:$E$113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NQO1'!$F$112:$F$113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577-45CB-8C2A-B3CDDD82B8DF}"/>
            </c:ext>
          </c:extLst>
        </c:ser>
        <c:ser>
          <c:idx val="1"/>
          <c:order val="1"/>
          <c:tx>
            <c:strRef>
              <c:f>'NQO1'!$G$111</c:f>
              <c:strCache>
                <c:ptCount val="1"/>
                <c:pt idx="0">
                  <c:v>PMA</c:v>
                </c:pt>
              </c:strCache>
            </c:strRef>
          </c:tx>
          <c:spPr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QO1'!$O$112:$O$113</c:f>
                <c:numCache>
                  <c:formatCode>General</c:formatCode>
                  <c:ptCount val="2"/>
                  <c:pt idx="0">
                    <c:v>0.0574559922374217</c:v>
                  </c:pt>
                  <c:pt idx="1">
                    <c:v>0.0174230988161041</c:v>
                  </c:pt>
                </c:numCache>
              </c:numRef>
            </c:plus>
            <c:minus>
              <c:numRef>
                <c:f>'NQO1'!$O$112:$O$113</c:f>
                <c:numCache>
                  <c:formatCode>General</c:formatCode>
                  <c:ptCount val="2"/>
                  <c:pt idx="0">
                    <c:v>0.0574559922374217</c:v>
                  </c:pt>
                  <c:pt idx="1">
                    <c:v>0.0174230988161041</c:v>
                  </c:pt>
                </c:numCache>
              </c:numRef>
            </c:minus>
          </c:errBars>
          <c:cat>
            <c:strRef>
              <c:f>'NQO1'!$E$112:$E$113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NQO1'!$G$112:$G$113</c:f>
              <c:numCache>
                <c:formatCode>General</c:formatCode>
                <c:ptCount val="2"/>
                <c:pt idx="0">
                  <c:v>0.683101301381505</c:v>
                </c:pt>
                <c:pt idx="1">
                  <c:v>0.84216246944845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577-45CB-8C2A-B3CDDD82B8DF}"/>
            </c:ext>
          </c:extLst>
        </c:ser>
        <c:ser>
          <c:idx val="2"/>
          <c:order val="2"/>
          <c:tx>
            <c:strRef>
              <c:f>'NQO1'!$H$111</c:f>
              <c:strCache>
                <c:ptCount val="1"/>
                <c:pt idx="0">
                  <c:v>PMA+DV2 MOI 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QO1'!$P$112:$P$113</c:f>
                <c:numCache>
                  <c:formatCode>General</c:formatCode>
                  <c:ptCount val="2"/>
                  <c:pt idx="0">
                    <c:v>0.425480090190102</c:v>
                  </c:pt>
                  <c:pt idx="1">
                    <c:v>0.361142739289299</c:v>
                  </c:pt>
                </c:numCache>
              </c:numRef>
            </c:plus>
            <c:minus>
              <c:numRef>
                <c:f>'NQO1'!$P$112:$P$113</c:f>
                <c:numCache>
                  <c:formatCode>General</c:formatCode>
                  <c:ptCount val="2"/>
                  <c:pt idx="0">
                    <c:v>0.425480090190102</c:v>
                  </c:pt>
                  <c:pt idx="1">
                    <c:v>0.361142739289299</c:v>
                  </c:pt>
                </c:numCache>
              </c:numRef>
            </c:minus>
          </c:errBars>
          <c:cat>
            <c:strRef>
              <c:f>'NQO1'!$E$112:$E$113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NQO1'!$H$112:$H$113</c:f>
              <c:numCache>
                <c:formatCode>General</c:formatCode>
                <c:ptCount val="2"/>
                <c:pt idx="0">
                  <c:v>1.534979790160359</c:v>
                </c:pt>
                <c:pt idx="1">
                  <c:v>3.36660845554695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577-45CB-8C2A-B3CDDD82B8DF}"/>
            </c:ext>
          </c:extLst>
        </c:ser>
        <c:ser>
          <c:idx val="3"/>
          <c:order val="3"/>
          <c:tx>
            <c:strRef>
              <c:f>'NQO1'!$I$111</c:f>
              <c:strCache>
                <c:ptCount val="1"/>
                <c:pt idx="0">
                  <c:v>PMA+DV2 MOI 5</c:v>
                </c:pt>
              </c:strCache>
            </c:strRef>
          </c:tx>
          <c:spPr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NQO1'!$Q$112:$Q$113</c:f>
                <c:numCache>
                  <c:formatCode>General</c:formatCode>
                  <c:ptCount val="2"/>
                  <c:pt idx="0">
                    <c:v>0.0804421243744154</c:v>
                  </c:pt>
                  <c:pt idx="1">
                    <c:v>0.562652639186</c:v>
                  </c:pt>
                </c:numCache>
              </c:numRef>
            </c:plus>
            <c:minus>
              <c:numRef>
                <c:f>'NQO1'!$Q$112:$Q$113</c:f>
                <c:numCache>
                  <c:formatCode>General</c:formatCode>
                  <c:ptCount val="2"/>
                  <c:pt idx="0">
                    <c:v>0.0804421243744154</c:v>
                  </c:pt>
                  <c:pt idx="1">
                    <c:v>0.562652639186</c:v>
                  </c:pt>
                </c:numCache>
              </c:numRef>
            </c:minus>
          </c:errBars>
          <c:cat>
            <c:strRef>
              <c:f>'NQO1'!$E$112:$E$113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NQO1'!$I$112:$I$113</c:f>
              <c:numCache>
                <c:formatCode>General</c:formatCode>
                <c:ptCount val="2"/>
                <c:pt idx="0">
                  <c:v>1.389862203436346</c:v>
                </c:pt>
                <c:pt idx="1">
                  <c:v>5.17659864607585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577-45CB-8C2A-B3CDDD82B8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6869176"/>
        <c:axId val="1936872584"/>
      </c:barChart>
      <c:catAx>
        <c:axId val="19368691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36872584"/>
        <c:crosses val="autoZero"/>
        <c:auto val="1"/>
        <c:lblAlgn val="ctr"/>
        <c:lblOffset val="100"/>
        <c:noMultiLvlLbl val="0"/>
      </c:catAx>
      <c:valAx>
        <c:axId val="19368725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>
                    <a:latin typeface="Times New Roman"/>
                    <a:cs typeface="Times New Roman"/>
                  </a:defRPr>
                </a:pPr>
                <a:r>
                  <a:rPr lang="en-US" sz="1000" b="0" i="0" baseline="0" dirty="0">
                    <a:effectLst/>
                    <a:latin typeface="Times New Roman"/>
                    <a:cs typeface="Times New Roman"/>
                  </a:rPr>
                  <a:t>Relative fold change</a:t>
                </a:r>
                <a:endParaRPr lang="en-US" sz="1000" b="0" dirty="0">
                  <a:effectLst/>
                  <a:latin typeface="Times New Roman"/>
                  <a:cs typeface="Times New Roman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368691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9"/>
    </mc:Choice>
    <mc:Fallback>
      <c:style val="9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 dirty="0">
                <a:latin typeface="Times New Roman"/>
                <a:cs typeface="Times New Roman"/>
              </a:rPr>
              <a:t>GCLC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CLC!$G$112</c:f>
              <c:strCache>
                <c:ptCount val="1"/>
                <c:pt idx="0">
                  <c:v>Mock</c:v>
                </c:pt>
              </c:strCache>
            </c:strRef>
          </c:tx>
          <c:spPr>
            <a:solidFill>
              <a:srgbClr val="000000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CLC!$O$113:$O$114</c:f>
                <c:numCache>
                  <c:formatCode>General</c:formatCode>
                  <c:ptCount val="2"/>
                  <c:pt idx="0">
                    <c:v>0.101215555861716</c:v>
                  </c:pt>
                  <c:pt idx="1">
                    <c:v>0.101215555861716</c:v>
                  </c:pt>
                </c:numCache>
              </c:numRef>
            </c:plus>
            <c:minus>
              <c:numRef>
                <c:f>GCLC!$O$113:$O$114</c:f>
                <c:numCache>
                  <c:formatCode>General</c:formatCode>
                  <c:ptCount val="2"/>
                  <c:pt idx="0">
                    <c:v>0.101215555861716</c:v>
                  </c:pt>
                  <c:pt idx="1">
                    <c:v>0.101215555861716</c:v>
                  </c:pt>
                </c:numCache>
              </c:numRef>
            </c:minus>
          </c:errBars>
          <c:cat>
            <c:strRef>
              <c:f>GCLC!$F$113:$F$114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GCLC!$G$113:$G$114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659-4BB4-81EB-2F29F3E02858}"/>
            </c:ext>
          </c:extLst>
        </c:ser>
        <c:ser>
          <c:idx val="1"/>
          <c:order val="1"/>
          <c:tx>
            <c:strRef>
              <c:f>GCLC!$H$112</c:f>
              <c:strCache>
                <c:ptCount val="1"/>
                <c:pt idx="0">
                  <c:v>PMA</c:v>
                </c:pt>
              </c:strCache>
            </c:strRef>
          </c:tx>
          <c:spPr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CLC!$P$113:$P$114</c:f>
                <c:numCache>
                  <c:formatCode>General</c:formatCode>
                  <c:ptCount val="2"/>
                  <c:pt idx="0">
                    <c:v>0.102898279001411</c:v>
                  </c:pt>
                  <c:pt idx="1">
                    <c:v>0.0944372373399666</c:v>
                  </c:pt>
                </c:numCache>
              </c:numRef>
            </c:plus>
            <c:minus>
              <c:numRef>
                <c:f>GCLC!$P$113:$P$114</c:f>
                <c:numCache>
                  <c:formatCode>General</c:formatCode>
                  <c:ptCount val="2"/>
                  <c:pt idx="0">
                    <c:v>0.102898279001411</c:v>
                  </c:pt>
                  <c:pt idx="1">
                    <c:v>0.0944372373399666</c:v>
                  </c:pt>
                </c:numCache>
              </c:numRef>
            </c:minus>
          </c:errBars>
          <c:cat>
            <c:strRef>
              <c:f>GCLC!$F$113:$F$114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GCLC!$H$113:$H$114</c:f>
              <c:numCache>
                <c:formatCode>General</c:formatCode>
                <c:ptCount val="2"/>
                <c:pt idx="0">
                  <c:v>0.589677859715819</c:v>
                </c:pt>
                <c:pt idx="1">
                  <c:v>0.638509817577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659-4BB4-81EB-2F29F3E02858}"/>
            </c:ext>
          </c:extLst>
        </c:ser>
        <c:ser>
          <c:idx val="2"/>
          <c:order val="2"/>
          <c:tx>
            <c:strRef>
              <c:f>GCLC!$I$112</c:f>
              <c:strCache>
                <c:ptCount val="1"/>
                <c:pt idx="0">
                  <c:v>PMA+DV2 MOI 1</c:v>
                </c:pt>
              </c:strCache>
            </c:strRef>
          </c:tx>
          <c:spPr>
            <a:solidFill>
              <a:schemeClr val="bg1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GCLC!$Q$113:$Q$114</c:f>
                <c:numCache>
                  <c:formatCode>General</c:formatCode>
                  <c:ptCount val="2"/>
                  <c:pt idx="0">
                    <c:v>0.0405401613544075</c:v>
                  </c:pt>
                  <c:pt idx="1">
                    <c:v>0.373055617445405</c:v>
                  </c:pt>
                </c:numCache>
              </c:numRef>
            </c:plus>
            <c:minus>
              <c:numRef>
                <c:f>GCLC!$Q$113:$Q$114</c:f>
                <c:numCache>
                  <c:formatCode>General</c:formatCode>
                  <c:ptCount val="2"/>
                  <c:pt idx="0">
                    <c:v>0.0405401613544075</c:v>
                  </c:pt>
                  <c:pt idx="1">
                    <c:v>0.373055617445405</c:v>
                  </c:pt>
                </c:numCache>
              </c:numRef>
            </c:minus>
          </c:errBars>
          <c:cat>
            <c:strRef>
              <c:f>GCLC!$F$113:$F$114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GCLC!$I$113:$I$114</c:f>
              <c:numCache>
                <c:formatCode>General</c:formatCode>
                <c:ptCount val="2"/>
                <c:pt idx="0">
                  <c:v>0.856020541249112</c:v>
                </c:pt>
                <c:pt idx="1">
                  <c:v>2.28621672055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659-4BB4-81EB-2F29F3E02858}"/>
            </c:ext>
          </c:extLst>
        </c:ser>
        <c:ser>
          <c:idx val="3"/>
          <c:order val="3"/>
          <c:tx>
            <c:strRef>
              <c:f>GCLC!$J$112</c:f>
              <c:strCache>
                <c:ptCount val="1"/>
                <c:pt idx="0">
                  <c:v>PMA+DV2 MOI 5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GCLC!$R$113:$R$114</c:f>
                <c:numCache>
                  <c:formatCode>General</c:formatCode>
                  <c:ptCount val="2"/>
                  <c:pt idx="0">
                    <c:v>0.121602281318449</c:v>
                  </c:pt>
                  <c:pt idx="1">
                    <c:v>0.457236597720716</c:v>
                  </c:pt>
                </c:numCache>
              </c:numRef>
            </c:plus>
            <c:minus>
              <c:numRef>
                <c:f>GCLC!$R$113:$R$114</c:f>
                <c:numCache>
                  <c:formatCode>General</c:formatCode>
                  <c:ptCount val="2"/>
                  <c:pt idx="0">
                    <c:v>0.121602281318449</c:v>
                  </c:pt>
                  <c:pt idx="1">
                    <c:v>0.457236597720716</c:v>
                  </c:pt>
                </c:numCache>
              </c:numRef>
            </c:minus>
          </c:errBars>
          <c:cat>
            <c:strRef>
              <c:f>GCLC!$F$113:$F$114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GCLC!$J$113:$J$114</c:f>
              <c:numCache>
                <c:formatCode>General</c:formatCode>
                <c:ptCount val="2"/>
                <c:pt idx="0">
                  <c:v>0.994641034526776</c:v>
                </c:pt>
                <c:pt idx="1">
                  <c:v>2.7827530095969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1659-4BB4-81EB-2F29F3E028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6941288"/>
        <c:axId val="1936944696"/>
      </c:barChart>
      <c:catAx>
        <c:axId val="19369412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36944696"/>
        <c:crosses val="autoZero"/>
        <c:auto val="1"/>
        <c:lblAlgn val="ctr"/>
        <c:lblOffset val="100"/>
        <c:noMultiLvlLbl val="0"/>
      </c:catAx>
      <c:valAx>
        <c:axId val="19369446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>
                    <a:latin typeface="Times New Roman"/>
                    <a:cs typeface="Times New Roman"/>
                  </a:defRPr>
                </a:pPr>
                <a:r>
                  <a:rPr lang="en-US" sz="1000" b="0" dirty="0">
                    <a:latin typeface="Times New Roman"/>
                    <a:cs typeface="Times New Roman"/>
                  </a:rPr>
                  <a:t>Relative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369412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9"/>
    </mc:Choice>
    <mc:Fallback>
      <c:style val="9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 dirty="0">
                <a:latin typeface="Times New Roman"/>
                <a:cs typeface="Times New Roman"/>
              </a:rPr>
              <a:t>SOD2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OD2'!$G$109</c:f>
              <c:strCache>
                <c:ptCount val="1"/>
                <c:pt idx="0">
                  <c:v>Mock</c:v>
                </c:pt>
              </c:strCache>
            </c:strRef>
          </c:tx>
          <c:spPr>
            <a:solidFill>
              <a:schemeClr val="tx1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OD2'!$O$110:$O$111</c:f>
                <c:numCache>
                  <c:formatCode>General</c:formatCode>
                  <c:ptCount val="2"/>
                  <c:pt idx="0">
                    <c:v>0.0677996463910196</c:v>
                  </c:pt>
                  <c:pt idx="1">
                    <c:v>0.0677996463910196</c:v>
                  </c:pt>
                </c:numCache>
              </c:numRef>
            </c:plus>
            <c:minus>
              <c:numRef>
                <c:f>'SOD2'!$O$110:$O$111</c:f>
                <c:numCache>
                  <c:formatCode>General</c:formatCode>
                  <c:ptCount val="2"/>
                  <c:pt idx="0">
                    <c:v>0.0677996463910196</c:v>
                  </c:pt>
                  <c:pt idx="1">
                    <c:v>0.0677996463910196</c:v>
                  </c:pt>
                </c:numCache>
              </c:numRef>
            </c:minus>
          </c:errBars>
          <c:cat>
            <c:strRef>
              <c:f>'SOD2'!$F$110:$F$111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SOD2'!$G$110:$G$111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68A-41C3-B011-C22E0268582C}"/>
            </c:ext>
          </c:extLst>
        </c:ser>
        <c:ser>
          <c:idx val="1"/>
          <c:order val="1"/>
          <c:tx>
            <c:strRef>
              <c:f>'SOD2'!$H$109</c:f>
              <c:strCache>
                <c:ptCount val="1"/>
                <c:pt idx="0">
                  <c:v>PMA</c:v>
                </c:pt>
              </c:strCache>
            </c:strRef>
          </c:tx>
          <c:spPr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OD2'!$P$110:$P$111</c:f>
                <c:numCache>
                  <c:formatCode>General</c:formatCode>
                  <c:ptCount val="2"/>
                  <c:pt idx="0">
                    <c:v>0.0516165809566752</c:v>
                  </c:pt>
                  <c:pt idx="1">
                    <c:v>0.254408611749168</c:v>
                  </c:pt>
                </c:numCache>
              </c:numRef>
            </c:plus>
            <c:minus>
              <c:numRef>
                <c:f>'SOD2'!$P$110:$P$111</c:f>
                <c:numCache>
                  <c:formatCode>General</c:formatCode>
                  <c:ptCount val="2"/>
                  <c:pt idx="0">
                    <c:v>0.0516165809566752</c:v>
                  </c:pt>
                  <c:pt idx="1">
                    <c:v>0.254408611749168</c:v>
                  </c:pt>
                </c:numCache>
              </c:numRef>
            </c:minus>
          </c:errBars>
          <c:cat>
            <c:strRef>
              <c:f>'SOD2'!$F$110:$F$111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SOD2'!$H$110:$H$111</c:f>
              <c:numCache>
                <c:formatCode>General</c:formatCode>
                <c:ptCount val="2"/>
                <c:pt idx="0">
                  <c:v>0.5227419472068</c:v>
                </c:pt>
                <c:pt idx="1">
                  <c:v>1.1649241574751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68A-41C3-B011-C22E0268582C}"/>
            </c:ext>
          </c:extLst>
        </c:ser>
        <c:ser>
          <c:idx val="2"/>
          <c:order val="2"/>
          <c:tx>
            <c:strRef>
              <c:f>'SOD2'!$I$109</c:f>
              <c:strCache>
                <c:ptCount val="1"/>
                <c:pt idx="0">
                  <c:v>PMA+DV2 MOI 1</c:v>
                </c:pt>
              </c:strCache>
            </c:strRef>
          </c:tx>
          <c:spPr>
            <a:solidFill>
              <a:srgbClr val="FFFF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SOD2'!$Q$110:$Q$111</c:f>
                <c:numCache>
                  <c:formatCode>General</c:formatCode>
                  <c:ptCount val="2"/>
                  <c:pt idx="0">
                    <c:v>0.71015765096273</c:v>
                  </c:pt>
                  <c:pt idx="1">
                    <c:v>3.055082305282522</c:v>
                  </c:pt>
                </c:numCache>
              </c:numRef>
            </c:plus>
            <c:minus>
              <c:numRef>
                <c:f>'SOD2'!$Q$110:$Q$111</c:f>
                <c:numCache>
                  <c:formatCode>General</c:formatCode>
                  <c:ptCount val="2"/>
                  <c:pt idx="0">
                    <c:v>0.71015765096273</c:v>
                  </c:pt>
                  <c:pt idx="1">
                    <c:v>3.055082305282522</c:v>
                  </c:pt>
                </c:numCache>
              </c:numRef>
            </c:minus>
          </c:errBars>
          <c:cat>
            <c:strRef>
              <c:f>'SOD2'!$F$110:$F$111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SOD2'!$I$110:$I$111</c:f>
              <c:numCache>
                <c:formatCode>General</c:formatCode>
                <c:ptCount val="2"/>
                <c:pt idx="0">
                  <c:v>3.734680813828107</c:v>
                </c:pt>
                <c:pt idx="1">
                  <c:v>16.513760971382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68A-41C3-B011-C22E0268582C}"/>
            </c:ext>
          </c:extLst>
        </c:ser>
        <c:ser>
          <c:idx val="3"/>
          <c:order val="3"/>
          <c:tx>
            <c:strRef>
              <c:f>'SOD2'!$J$109</c:f>
              <c:strCache>
                <c:ptCount val="1"/>
                <c:pt idx="0">
                  <c:v>PMA+DV2 MOI 5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OD2'!$R$110:$R$111</c:f>
                <c:numCache>
                  <c:formatCode>General</c:formatCode>
                  <c:ptCount val="2"/>
                  <c:pt idx="0">
                    <c:v>0.791294936685685</c:v>
                  </c:pt>
                  <c:pt idx="1">
                    <c:v>4.472248257981318</c:v>
                  </c:pt>
                </c:numCache>
              </c:numRef>
            </c:plus>
            <c:minus>
              <c:numRef>
                <c:f>'SOD2'!$R$110:$R$111</c:f>
                <c:numCache>
                  <c:formatCode>General</c:formatCode>
                  <c:ptCount val="2"/>
                  <c:pt idx="0">
                    <c:v>0.791294936685685</c:v>
                  </c:pt>
                  <c:pt idx="1">
                    <c:v>4.472248257981318</c:v>
                  </c:pt>
                </c:numCache>
              </c:numRef>
            </c:minus>
          </c:errBars>
          <c:cat>
            <c:strRef>
              <c:f>'SOD2'!$F$110:$F$111</c:f>
              <c:strCache>
                <c:ptCount val="2"/>
                <c:pt idx="0">
                  <c:v>DAY 3</c:v>
                </c:pt>
                <c:pt idx="1">
                  <c:v>DAY 6</c:v>
                </c:pt>
              </c:strCache>
            </c:strRef>
          </c:cat>
          <c:val>
            <c:numRef>
              <c:f>'SOD2'!$J$110:$J$111</c:f>
              <c:numCache>
                <c:formatCode>General</c:formatCode>
                <c:ptCount val="2"/>
                <c:pt idx="0">
                  <c:v>5.03174840917584</c:v>
                </c:pt>
                <c:pt idx="1">
                  <c:v>20.662285348917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D68A-41C3-B011-C22E026858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37612104"/>
        <c:axId val="1937379384"/>
      </c:barChart>
      <c:catAx>
        <c:axId val="19376121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37379384"/>
        <c:crosses val="autoZero"/>
        <c:auto val="1"/>
        <c:lblAlgn val="ctr"/>
        <c:lblOffset val="100"/>
        <c:noMultiLvlLbl val="0"/>
      </c:catAx>
      <c:valAx>
        <c:axId val="19373793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>
                    <a:latin typeface="Times New Roman"/>
                    <a:cs typeface="Times New Roman"/>
                  </a:defRPr>
                </a:pPr>
                <a:r>
                  <a:rPr lang="en-US" sz="1000" b="0" dirty="0">
                    <a:latin typeface="Times New Roman"/>
                    <a:cs typeface="Times New Roman"/>
                  </a:rPr>
                  <a:t>Relative fold chang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Times New Roman"/>
                <a:cs typeface="Times New Roman"/>
              </a:defRPr>
            </a:pPr>
            <a:endParaRPr lang="en-US"/>
          </a:p>
        </c:txPr>
        <c:crossAx val="19376121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9755</cdr:x>
      <cdr:y>0.15272</cdr:y>
    </cdr:from>
    <cdr:to>
      <cdr:x>0.6053</cdr:x>
      <cdr:y>0.2318</cdr:y>
    </cdr:to>
    <cdr:grpSp>
      <cdr:nvGrpSpPr>
        <cdr:cNvPr id="8" name="Group 7">
          <a:extLst xmlns:a="http://schemas.openxmlformats.org/drawingml/2006/main">
            <a:ext uri="{FF2B5EF4-FFF2-40B4-BE49-F238E27FC236}">
              <a16:creationId xmlns:a16="http://schemas.microsoft.com/office/drawing/2014/main" xmlns="" id="{72020E59-6878-4A73-9DCB-90C909278FEC}"/>
            </a:ext>
          </a:extLst>
        </cdr:cNvPr>
        <cdr:cNvGrpSpPr/>
      </cdr:nvGrpSpPr>
      <cdr:grpSpPr>
        <a:xfrm xmlns:a="http://schemas.openxmlformats.org/drawingml/2006/main">
          <a:off x="1129732" y="402477"/>
          <a:ext cx="244656" cy="208406"/>
          <a:chOff x="2445451" y="369156"/>
          <a:chExt cx="492658" cy="215438"/>
        </a:xfrm>
      </cdr:grpSpPr>
      <cdr:cxnSp macro="">
        <cdr:nvCxnSpPr>
          <cdr:cNvPr id="6" name="Straight Connector 5">
            <a:extLst xmlns:a="http://schemas.openxmlformats.org/drawingml/2006/main">
              <a:ext uri="{FF2B5EF4-FFF2-40B4-BE49-F238E27FC236}">
                <a16:creationId xmlns:a16="http://schemas.microsoft.com/office/drawing/2014/main" xmlns="" id="{9D8881D5-B1C0-42B1-87E2-313DF97C1DD6}"/>
              </a:ext>
            </a:extLst>
          </cdr:cNvPr>
          <cdr:cNvCxnSpPr/>
        </cdr:nvCxnSpPr>
        <cdr:spPr>
          <a:xfrm xmlns:a="http://schemas.openxmlformats.org/drawingml/2006/main">
            <a:off x="2456652" y="558114"/>
            <a:ext cx="481457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1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0">
            <a:schemeClr val="dk1"/>
          </a:effectRef>
          <a:fontRef xmlns:a="http://schemas.openxmlformats.org/drawingml/2006/main" idx="minor">
            <a:schemeClr val="tx1"/>
          </a:fontRef>
        </cdr:style>
      </cdr:cxnSp>
      <cdr:sp macro="" textlink="">
        <cdr:nvSpPr>
          <cdr:cNvPr id="7" name="TextBox 10">
            <a:extLst xmlns:a="http://schemas.openxmlformats.org/drawingml/2006/main">
              <a:ext uri="{FF2B5EF4-FFF2-40B4-BE49-F238E27FC236}">
                <a16:creationId xmlns:a16="http://schemas.microsoft.com/office/drawing/2014/main" xmlns="" id="{6D6B6787-C8B2-42B6-A56A-23DF689BE6A9}"/>
              </a:ext>
            </a:extLst>
          </cdr:cNvPr>
          <cdr:cNvSpPr txBox="1"/>
        </cdr:nvSpPr>
        <cdr:spPr>
          <a:xfrm xmlns:a="http://schemas.openxmlformats.org/drawingml/2006/main">
            <a:off x="2445451" y="369156"/>
            <a:ext cx="464405" cy="215438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squar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pPr algn="ctr"/>
            <a:r>
              <a:rPr lang="en-I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cdr:txBody>
      </cdr:sp>
    </cdr:grp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26B25D-C95A-DE4F-AAF3-9BDA5C542191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F78E15-2073-A445-8D2B-313A90657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26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F78E15-2073-A445-8D2B-313A90657F3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9609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824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46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232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257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798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602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859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025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763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529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68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69AE9A-B02D-1C4A-A631-2529FF8DAD72}" type="datetimeFigureOut">
              <a:rPr lang="en-US" smtClean="0"/>
              <a:t>29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58B0E-5FD5-354A-96C3-AEE819E607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551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5" Type="http://schemas.openxmlformats.org/officeDocument/2006/relationships/image" Target="../media/image4.jpg"/><Relationship Id="rId6" Type="http://schemas.openxmlformats.org/officeDocument/2006/relationships/chart" Target="../charts/chart1.xml"/><Relationship Id="rId7" Type="http://schemas.openxmlformats.org/officeDocument/2006/relationships/chart" Target="../charts/chart2.xml"/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4" Type="http://schemas.openxmlformats.org/officeDocument/2006/relationships/chart" Target="../charts/chart4.xml"/><Relationship Id="rId5" Type="http://schemas.openxmlformats.org/officeDocument/2006/relationships/chart" Target="../charts/chart5.xml"/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4" Type="http://schemas.openxmlformats.org/officeDocument/2006/relationships/chart" Target="../charts/chart8.xml"/><Relationship Id="rId5" Type="http://schemas.openxmlformats.org/officeDocument/2006/relationships/chart" Target="../charts/chart9.xml"/><Relationship Id="rId6" Type="http://schemas.openxmlformats.org/officeDocument/2006/relationships/chart" Target="../charts/chart10.xml"/><Relationship Id="rId7" Type="http://schemas.openxmlformats.org/officeDocument/2006/relationships/chart" Target="../charts/chart11.xml"/><Relationship Id="rId1" Type="http://schemas.openxmlformats.org/officeDocument/2006/relationships/slideLayout" Target="../slideLayouts/slideLayout6.xml"/><Relationship Id="rId2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image" Target="../media/image11.png"/><Relationship Id="rId9" Type="http://schemas.openxmlformats.org/officeDocument/2006/relationships/image" Target="../media/image12.png"/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D753A4D9-B147-F345-B985-12360231F695}"/>
              </a:ext>
            </a:extLst>
          </p:cNvPr>
          <p:cNvSpPr txBox="1"/>
          <p:nvPr/>
        </p:nvSpPr>
        <p:spPr>
          <a:xfrm>
            <a:off x="2540851" y="77695"/>
            <a:ext cx="17762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9B354175-B6D0-E24E-AFA3-1F69AFBD071F}"/>
              </a:ext>
            </a:extLst>
          </p:cNvPr>
          <p:cNvSpPr txBox="1"/>
          <p:nvPr/>
        </p:nvSpPr>
        <p:spPr>
          <a:xfrm>
            <a:off x="3046773" y="8833815"/>
            <a:ext cx="818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1" name="Group 100"/>
          <p:cNvGrpSpPr/>
          <p:nvPr/>
        </p:nvGrpSpPr>
        <p:grpSpPr>
          <a:xfrm>
            <a:off x="133772" y="2902275"/>
            <a:ext cx="5733247" cy="3531993"/>
            <a:chOff x="98709" y="3304088"/>
            <a:chExt cx="5733247" cy="3531993"/>
          </a:xfrm>
        </p:grpSpPr>
        <p:sp>
          <p:nvSpPr>
            <p:cNvPr id="7" name="TextBox 6"/>
            <p:cNvSpPr txBox="1"/>
            <p:nvPr/>
          </p:nvSpPr>
          <p:spPr>
            <a:xfrm>
              <a:off x="2263594" y="6238704"/>
              <a:ext cx="25297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/>
                  <a:cs typeface="Times New Roman"/>
                </a:rPr>
                <a:t>MOLECULAR FUNCTIONS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73626" y="3304088"/>
              <a:ext cx="25878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/>
                  <a:cs typeface="Times New Roman"/>
                </a:rPr>
                <a:t>CELLULAR COMPONENTS</a:t>
              </a: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1365599" y="6559082"/>
              <a:ext cx="94524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 smtClean="0">
                  <a:latin typeface="Times New Roman"/>
                  <a:cs typeface="Times New Roman"/>
                </a:rPr>
                <a:t>Upregulated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4698312" y="6501268"/>
              <a:ext cx="11336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 smtClean="0">
                  <a:latin typeface="Times New Roman"/>
                  <a:cs typeface="Times New Roman"/>
                </a:rPr>
                <a:t>Downregulated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314110" y="3580370"/>
              <a:ext cx="94524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 smtClean="0">
                  <a:latin typeface="Times New Roman"/>
                  <a:cs typeface="Times New Roman"/>
                </a:rPr>
                <a:t>Upregulated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4685899" y="3582558"/>
              <a:ext cx="11336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 smtClean="0">
                  <a:latin typeface="Times New Roman"/>
                  <a:cs typeface="Times New Roman"/>
                </a:rPr>
                <a:t>Downregulated</a:t>
              </a:r>
              <a:endParaRPr 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BFD1DA6E-1FF8-1243-95BB-FBD3FE0A7736}"/>
                </a:ext>
              </a:extLst>
            </p:cNvPr>
            <p:cNvSpPr txBox="1"/>
            <p:nvPr/>
          </p:nvSpPr>
          <p:spPr>
            <a:xfrm>
              <a:off x="98709" y="331965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BFD1DA6E-1FF8-1243-95BB-FBD3FE0A7736}"/>
                </a:ext>
              </a:extLst>
            </p:cNvPr>
            <p:cNvSpPr txBox="1"/>
            <p:nvPr/>
          </p:nvSpPr>
          <p:spPr>
            <a:xfrm>
              <a:off x="117843" y="6263346"/>
              <a:ext cx="29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9B354175-B6D0-E24E-AFA3-1F69AFBD071F}"/>
              </a:ext>
            </a:extLst>
          </p:cNvPr>
          <p:cNvSpPr txBox="1"/>
          <p:nvPr/>
        </p:nvSpPr>
        <p:spPr>
          <a:xfrm>
            <a:off x="1265045" y="2562109"/>
            <a:ext cx="818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 descr="SuppGO CC Up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878" y="3470323"/>
            <a:ext cx="3348000" cy="2383953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3" name="Picture 2" descr="Sup down CC.jpg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749" b="5701"/>
          <a:stretch/>
        </p:blipFill>
        <p:spPr>
          <a:xfrm>
            <a:off x="3480693" y="3465325"/>
            <a:ext cx="3348000" cy="237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 descr="SupUp_MF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832" y="6432855"/>
            <a:ext cx="3338816" cy="2377413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Picture 4" descr="Sup Down MF.jpg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504"/>
          <a:stretch/>
        </p:blipFill>
        <p:spPr>
          <a:xfrm>
            <a:off x="3477724" y="6432855"/>
            <a:ext cx="3348000" cy="237600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9B354175-B6D0-E24E-AFA3-1F69AFBD071F}"/>
              </a:ext>
            </a:extLst>
          </p:cNvPr>
          <p:cNvSpPr txBox="1"/>
          <p:nvPr/>
        </p:nvSpPr>
        <p:spPr>
          <a:xfrm>
            <a:off x="4759179" y="2523624"/>
            <a:ext cx="818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646248" y="516856"/>
            <a:ext cx="2198243" cy="2034692"/>
            <a:chOff x="4063597" y="403374"/>
            <a:chExt cx="2198243" cy="2034692"/>
          </a:xfrm>
        </p:grpSpPr>
        <p:graphicFrame>
          <p:nvGraphicFramePr>
            <p:cNvPr id="24" name="Chart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7884821"/>
                </p:ext>
              </p:extLst>
            </p:nvPr>
          </p:nvGraphicFramePr>
          <p:xfrm>
            <a:off x="4063597" y="403374"/>
            <a:ext cx="2198243" cy="20346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26" name="TextBox 25">
              <a:extLst>
                <a:ext uri="{FF2B5EF4-FFF2-40B4-BE49-F238E27FC236}">
  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6D6B6787-C8B2-42B6-A56A-23DF689BE6A9}"/>
                </a:ext>
              </a:extLst>
            </p:cNvPr>
            <p:cNvSpPr txBox="1"/>
            <p:nvPr/>
          </p:nvSpPr>
          <p:spPr>
            <a:xfrm>
              <a:off x="5180315" y="524553"/>
              <a:ext cx="3688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en-I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xmlns="" id="{5EF73529-9DD1-486A-A1B3-05D225A01D72}"/>
                </a:ext>
              </a:extLst>
            </p:cNvPr>
            <p:cNvCxnSpPr/>
            <p:nvPr/>
          </p:nvCxnSpPr>
          <p:spPr>
            <a:xfrm>
              <a:off x="5280071" y="686118"/>
              <a:ext cx="179999" cy="0"/>
            </a:xfrm>
            <a:prstGeom prst="line">
              <a:avLst/>
            </a:prstGeom>
            <a:ln w="3175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xmlns="" id="{5EF73529-9DD1-486A-A1B3-05D225A01D72}"/>
                </a:ext>
              </a:extLst>
            </p:cNvPr>
            <p:cNvCxnSpPr/>
            <p:nvPr/>
          </p:nvCxnSpPr>
          <p:spPr>
            <a:xfrm>
              <a:off x="4802618" y="1746760"/>
              <a:ext cx="179999" cy="0"/>
            </a:xfrm>
            <a:prstGeom prst="line">
              <a:avLst/>
            </a:prstGeom>
            <a:ln w="3175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6D6B6787-C8B2-42B6-A56A-23DF689BE6A9}"/>
                </a:ext>
              </a:extLst>
            </p:cNvPr>
            <p:cNvSpPr txBox="1"/>
            <p:nvPr/>
          </p:nvSpPr>
          <p:spPr>
            <a:xfrm>
              <a:off x="4700549" y="1585195"/>
              <a:ext cx="3688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en-I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xmlns="" id="{2E0DE7BA-66B7-6848-B387-25904A8A7E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3681883"/>
              </p:ext>
            </p:extLst>
          </p:nvPr>
        </p:nvGraphicFramePr>
        <p:xfrm>
          <a:off x="4139207" y="218805"/>
          <a:ext cx="2270589" cy="26353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3001267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F99948DB-D252-41E4-A25C-11FFB85F516B}"/>
              </a:ext>
            </a:extLst>
          </p:cNvPr>
          <p:cNvGrpSpPr/>
          <p:nvPr/>
        </p:nvGrpSpPr>
        <p:grpSpPr>
          <a:xfrm>
            <a:off x="453345" y="132412"/>
            <a:ext cx="6346526" cy="7500987"/>
            <a:chOff x="453345" y="132412"/>
            <a:chExt cx="6346526" cy="7500987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9B354175-B6D0-E24E-AFA3-1F69AFBD071F}"/>
                </a:ext>
              </a:extLst>
            </p:cNvPr>
            <p:cNvSpPr txBox="1"/>
            <p:nvPr/>
          </p:nvSpPr>
          <p:spPr>
            <a:xfrm>
              <a:off x="3019611" y="3292807"/>
              <a:ext cx="819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4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9B354175-B6D0-E24E-AFA3-1F69AFBD071F}"/>
                </a:ext>
              </a:extLst>
            </p:cNvPr>
            <p:cNvSpPr txBox="1"/>
            <p:nvPr/>
          </p:nvSpPr>
          <p:spPr>
            <a:xfrm>
              <a:off x="3019611" y="7356400"/>
              <a:ext cx="819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5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5212343" y="6797290"/>
              <a:ext cx="1587528" cy="786820"/>
              <a:chOff x="10877512" y="-4659951"/>
              <a:chExt cx="1377481" cy="895893"/>
            </a:xfrm>
          </p:grpSpPr>
          <p:sp>
            <p:nvSpPr>
              <p:cNvPr id="60" name="Rectangle 59"/>
              <p:cNvSpPr/>
              <p:nvPr/>
            </p:nvSpPr>
            <p:spPr>
              <a:xfrm>
                <a:off x="10879220" y="-4553229"/>
                <a:ext cx="108000" cy="108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10877512" y="-4351574"/>
                <a:ext cx="108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10881940" y="-4131334"/>
                <a:ext cx="108000" cy="108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10880173" y="-3923423"/>
                <a:ext cx="108000" cy="108000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10999859" y="-4659951"/>
                <a:ext cx="916877" cy="2803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/>
                    <a:cs typeface="Times New Roman"/>
                  </a:rPr>
                  <a:t>Untreated</a:t>
                </a:r>
                <a:r>
                  <a:rPr lang="en-US" sz="1000" dirty="0">
                    <a:latin typeface="Times New Roman"/>
                    <a:cs typeface="Times New Roman"/>
                  </a:rPr>
                  <a:t> </a:t>
                </a:r>
                <a:r>
                  <a:rPr lang="en-US" sz="800" dirty="0">
                    <a:latin typeface="Times New Roman"/>
                    <a:cs typeface="Times New Roman"/>
                  </a:rPr>
                  <a:t>Mock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11005084" y="-4445600"/>
                <a:ext cx="408879" cy="2453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/>
                    <a:cs typeface="Times New Roman"/>
                  </a:rPr>
                  <a:t>PMA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11008802" y="-4222381"/>
                <a:ext cx="1243980" cy="2453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/>
                    <a:cs typeface="Times New Roman"/>
                  </a:rPr>
                  <a:t>PMA + DENV (MOI1)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11011013" y="-4009368"/>
                <a:ext cx="1243980" cy="2453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/>
                    <a:cs typeface="Times New Roman"/>
                  </a:rPr>
                  <a:t>PMA + DENV (MOI5)</a:t>
                </a: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2141088" y="132412"/>
              <a:ext cx="2649720" cy="3090496"/>
              <a:chOff x="2141088" y="132412"/>
              <a:chExt cx="2649720" cy="3090496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141088" y="132412"/>
                <a:ext cx="2649720" cy="3090496"/>
              </a:xfrm>
              <a:prstGeom prst="rect">
                <a:avLst/>
              </a:prstGeom>
            </p:spPr>
          </p:pic>
          <p:sp>
            <p:nvSpPr>
              <p:cNvPr id="68" name="Frame 67"/>
              <p:cNvSpPr/>
              <p:nvPr/>
            </p:nvSpPr>
            <p:spPr>
              <a:xfrm rot="18660955">
                <a:off x="3779495" y="564729"/>
                <a:ext cx="593379" cy="160694"/>
              </a:xfrm>
              <a:prstGeom prst="fram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453345" y="4220700"/>
              <a:ext cx="1800000" cy="2445561"/>
              <a:chOff x="945351" y="3615071"/>
              <a:chExt cx="1800000" cy="2445561"/>
            </a:xfrm>
          </p:grpSpPr>
          <p:graphicFrame>
            <p:nvGraphicFramePr>
              <p:cNvPr id="69" name="Chart 6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876983108"/>
                  </p:ext>
                </p:extLst>
              </p:nvPr>
            </p:nvGraphicFramePr>
            <p:xfrm>
              <a:off x="945351" y="3615071"/>
              <a:ext cx="1800000" cy="244556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xmlns="" id="{0049345E-C09F-6B4C-BB3B-AA667428CAB8}"/>
                  </a:ext>
                </a:extLst>
              </p:cNvPr>
              <p:cNvSpPr txBox="1"/>
              <p:nvPr/>
            </p:nvSpPr>
            <p:spPr>
              <a:xfrm>
                <a:off x="2179804" y="4300774"/>
                <a:ext cx="26635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700" dirty="0">
                    <a:latin typeface="Times New Roman"/>
                    <a:cs typeface="Times New Roman"/>
                  </a:rPr>
                  <a:t>*</a:t>
                </a:r>
              </a:p>
            </p:txBody>
          </p: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xmlns="" id="{49D2B537-13BB-6045-97AA-3C22839D8ACB}"/>
                  </a:ext>
                </a:extLst>
              </p:cNvPr>
              <p:cNvCxnSpPr/>
              <p:nvPr/>
            </p:nvCxnSpPr>
            <p:spPr>
              <a:xfrm>
                <a:off x="2220577" y="4439777"/>
                <a:ext cx="135405" cy="0"/>
              </a:xfrm>
              <a:prstGeom prst="line">
                <a:avLst/>
              </a:prstGeom>
              <a:ln w="3175" cmpd="sng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81" name="Chart 8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20977474"/>
                </p:ext>
              </p:extLst>
            </p:nvPr>
          </p:nvGraphicFramePr>
          <p:xfrm>
            <a:off x="4469433" y="4175435"/>
            <a:ext cx="1840553" cy="24455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8" name="Group 7"/>
            <p:cNvGrpSpPr/>
            <p:nvPr/>
          </p:nvGrpSpPr>
          <p:grpSpPr>
            <a:xfrm>
              <a:off x="2519403" y="4209208"/>
              <a:ext cx="1800000" cy="2448000"/>
              <a:chOff x="2539971" y="4153816"/>
              <a:chExt cx="1800000" cy="2448000"/>
            </a:xfrm>
          </p:grpSpPr>
          <p:graphicFrame>
            <p:nvGraphicFramePr>
              <p:cNvPr id="76" name="Chart 7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65900869"/>
                  </p:ext>
                </p:extLst>
              </p:nvPr>
            </p:nvGraphicFramePr>
            <p:xfrm>
              <a:off x="2539971" y="4153816"/>
              <a:ext cx="1800000" cy="2448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xmlns="" id="{0049345E-C09F-6B4C-BB3B-AA667428CAB8}"/>
                  </a:ext>
                </a:extLst>
              </p:cNvPr>
              <p:cNvSpPr txBox="1"/>
              <p:nvPr/>
            </p:nvSpPr>
            <p:spPr>
              <a:xfrm>
                <a:off x="3793442" y="4550414"/>
                <a:ext cx="40291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700" dirty="0">
                    <a:latin typeface="Times New Roman"/>
                    <a:cs typeface="Times New Roman"/>
                  </a:rPr>
                  <a:t>** </a:t>
                </a:r>
              </a:p>
            </p:txBody>
          </p:sp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xmlns="" id="{49D2B537-13BB-6045-97AA-3C22839D8ACB}"/>
                  </a:ext>
                </a:extLst>
              </p:cNvPr>
              <p:cNvCxnSpPr/>
              <p:nvPr/>
            </p:nvCxnSpPr>
            <p:spPr>
              <a:xfrm>
                <a:off x="3804546" y="4689347"/>
                <a:ext cx="251999" cy="0"/>
              </a:xfrm>
              <a:prstGeom prst="line">
                <a:avLst/>
              </a:prstGeom>
              <a:ln w="3175" cmpd="sng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xmlns="" id="{49D2B537-13BB-6045-97AA-3C22839D8ACB}"/>
                </a:ext>
              </a:extLst>
            </p:cNvPr>
            <p:cNvCxnSpPr/>
            <p:nvPr/>
          </p:nvCxnSpPr>
          <p:spPr>
            <a:xfrm>
              <a:off x="5795189" y="4751811"/>
              <a:ext cx="251999" cy="0"/>
            </a:xfrm>
            <a:prstGeom prst="line">
              <a:avLst/>
            </a:prstGeom>
            <a:ln w="3175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xmlns="" id="{0049345E-C09F-6B4C-BB3B-AA667428CAB8}"/>
                </a:ext>
              </a:extLst>
            </p:cNvPr>
            <p:cNvSpPr txBox="1"/>
            <p:nvPr/>
          </p:nvSpPr>
          <p:spPr>
            <a:xfrm>
              <a:off x="5779881" y="4629378"/>
              <a:ext cx="54037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700" dirty="0">
                  <a:latin typeface="Times New Roman"/>
                  <a:cs typeface="Times New Roman"/>
                </a:rPr>
                <a:t>** </a:t>
              </a:r>
            </a:p>
          </p:txBody>
        </p: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xmlns="" id="{49D2B537-13BB-6045-97AA-3C22839D8ACB}"/>
                </a:ext>
              </a:extLst>
            </p:cNvPr>
            <p:cNvCxnSpPr/>
            <p:nvPr/>
          </p:nvCxnSpPr>
          <p:spPr>
            <a:xfrm>
              <a:off x="5803187" y="5001882"/>
              <a:ext cx="135405" cy="0"/>
            </a:xfrm>
            <a:prstGeom prst="line">
              <a:avLst/>
            </a:prstGeom>
            <a:ln w="3175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xmlns="" id="{0049345E-C09F-6B4C-BB3B-AA667428CAB8}"/>
                </a:ext>
              </a:extLst>
            </p:cNvPr>
            <p:cNvSpPr txBox="1"/>
            <p:nvPr/>
          </p:nvSpPr>
          <p:spPr>
            <a:xfrm>
              <a:off x="5732883" y="4875915"/>
              <a:ext cx="30385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700" dirty="0">
                  <a:latin typeface="Times New Roman"/>
                  <a:cs typeface="Times New Roman"/>
                </a:rPr>
                <a:t>** 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3339581B-1998-4A93-9533-AA3205BB15AE}"/>
                </a:ext>
              </a:extLst>
            </p:cNvPr>
            <p:cNvSpPr txBox="1"/>
            <p:nvPr/>
          </p:nvSpPr>
          <p:spPr>
            <a:xfrm>
              <a:off x="1713126" y="4670027"/>
              <a:ext cx="35471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700" dirty="0">
                  <a:latin typeface="Times New Roman"/>
                  <a:cs typeface="Times New Roman"/>
                </a:rPr>
                <a:t>** </a:t>
              </a:r>
            </a:p>
          </p:txBody>
        </p: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xmlns="" id="{5EF73529-9DD1-486A-A1B3-05D225A01D72}"/>
                </a:ext>
              </a:extLst>
            </p:cNvPr>
            <p:cNvCxnSpPr/>
            <p:nvPr/>
          </p:nvCxnSpPr>
          <p:spPr>
            <a:xfrm>
              <a:off x="1718738" y="4803997"/>
              <a:ext cx="268466" cy="0"/>
            </a:xfrm>
            <a:prstGeom prst="line">
              <a:avLst/>
            </a:prstGeom>
            <a:ln w="3175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xmlns="" id="{CEB59160-800C-4ABC-8FD6-9CABCF3D66F2}"/>
                </a:ext>
              </a:extLst>
            </p:cNvPr>
            <p:cNvSpPr txBox="1"/>
            <p:nvPr/>
          </p:nvSpPr>
          <p:spPr>
            <a:xfrm>
              <a:off x="3759592" y="4857745"/>
              <a:ext cx="26635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700" dirty="0">
                  <a:latin typeface="Times New Roman"/>
                  <a:cs typeface="Times New Roman"/>
                </a:rPr>
                <a:t>*</a:t>
              </a:r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xmlns="" id="{428B9F84-D28A-4FF8-BB2B-59825F48A780}"/>
                </a:ext>
              </a:extLst>
            </p:cNvPr>
            <p:cNvCxnSpPr/>
            <p:nvPr/>
          </p:nvCxnSpPr>
          <p:spPr>
            <a:xfrm>
              <a:off x="3800428" y="4985712"/>
              <a:ext cx="135405" cy="0"/>
            </a:xfrm>
            <a:prstGeom prst="line">
              <a:avLst/>
            </a:prstGeom>
            <a:ln w="3175" cmpd="sng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790972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68186" y="209700"/>
            <a:ext cx="6344657" cy="8296102"/>
            <a:chOff x="768186" y="209700"/>
            <a:chExt cx="6344657" cy="8296102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9B354175-B6D0-E24E-AFA3-1F69AFBD071F}"/>
                </a:ext>
              </a:extLst>
            </p:cNvPr>
            <p:cNvSpPr txBox="1"/>
            <p:nvPr/>
          </p:nvSpPr>
          <p:spPr>
            <a:xfrm>
              <a:off x="3019611" y="8228803"/>
              <a:ext cx="819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6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5525315" y="209700"/>
              <a:ext cx="1587528" cy="786820"/>
              <a:chOff x="10877512" y="-4659951"/>
              <a:chExt cx="1377481" cy="895893"/>
            </a:xfrm>
          </p:grpSpPr>
          <p:sp>
            <p:nvSpPr>
              <p:cNvPr id="60" name="Rectangle 59"/>
              <p:cNvSpPr/>
              <p:nvPr/>
            </p:nvSpPr>
            <p:spPr>
              <a:xfrm>
                <a:off x="10879220" y="-4553229"/>
                <a:ext cx="108000" cy="108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10877512" y="-4351574"/>
                <a:ext cx="108000" cy="108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10881940" y="-4131334"/>
                <a:ext cx="108000" cy="108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10880173" y="-3923423"/>
                <a:ext cx="108000" cy="108000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>
                <a:solidFill>
                  <a:srgbClr val="00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10999859" y="-4659951"/>
                <a:ext cx="916877" cy="2803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/>
                    <a:cs typeface="Times New Roman"/>
                  </a:rPr>
                  <a:t>Untreated</a:t>
                </a:r>
                <a:r>
                  <a:rPr lang="en-US" sz="1000" dirty="0">
                    <a:latin typeface="Times New Roman"/>
                    <a:cs typeface="Times New Roman"/>
                  </a:rPr>
                  <a:t> </a:t>
                </a:r>
                <a:r>
                  <a:rPr lang="en-US" sz="800" dirty="0">
                    <a:latin typeface="Times New Roman"/>
                    <a:cs typeface="Times New Roman"/>
                  </a:rPr>
                  <a:t>Mock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11005084" y="-4445600"/>
                <a:ext cx="408879" cy="2453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/>
                    <a:cs typeface="Times New Roman"/>
                  </a:rPr>
                  <a:t>PMA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11008802" y="-4222381"/>
                <a:ext cx="1243980" cy="2453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/>
                    <a:cs typeface="Times New Roman"/>
                  </a:rPr>
                  <a:t>PMA + DENV (MOI1)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11011013" y="-4009368"/>
                <a:ext cx="1243980" cy="2453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/>
                    <a:cs typeface="Times New Roman"/>
                  </a:rPr>
                  <a:t>PMA + DENV (MOI5)</a:t>
                </a: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768186" y="3158628"/>
              <a:ext cx="4896770" cy="4960822"/>
              <a:chOff x="3797353" y="783961"/>
              <a:chExt cx="4896770" cy="4960822"/>
            </a:xfrm>
          </p:grpSpPr>
          <p:grpSp>
            <p:nvGrpSpPr>
              <p:cNvPr id="17" name="Group 16"/>
              <p:cNvGrpSpPr/>
              <p:nvPr/>
            </p:nvGrpSpPr>
            <p:grpSpPr>
              <a:xfrm>
                <a:off x="4048198" y="874922"/>
                <a:ext cx="4645925" cy="4869861"/>
                <a:chOff x="2559532" y="699079"/>
                <a:chExt cx="6284698" cy="5277218"/>
              </a:xfrm>
            </p:grpSpPr>
            <p:graphicFrame>
              <p:nvGraphicFramePr>
                <p:cNvPr id="22" name="Chart 2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498362884"/>
                    </p:ext>
                  </p:extLst>
                </p:nvPr>
              </p:nvGraphicFramePr>
              <p:xfrm>
                <a:off x="2559532" y="700396"/>
                <a:ext cx="2434920" cy="245771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23" name="Chart 2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180555728"/>
                    </p:ext>
                  </p:extLst>
                </p:nvPr>
              </p:nvGraphicFramePr>
              <p:xfrm>
                <a:off x="6259353" y="699079"/>
                <a:ext cx="2426135" cy="244516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24" name="Chart 2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660814688"/>
                    </p:ext>
                  </p:extLst>
                </p:nvPr>
              </p:nvGraphicFramePr>
              <p:xfrm>
                <a:off x="6194903" y="3281752"/>
                <a:ext cx="2649327" cy="269454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aphicFrame>
              <p:nvGraphicFramePr>
                <p:cNvPr id="25" name="Chart 2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588792681"/>
                    </p:ext>
                  </p:extLst>
                </p:nvPr>
              </p:nvGraphicFramePr>
              <p:xfrm>
                <a:off x="2603331" y="3372474"/>
                <a:ext cx="2567143" cy="259248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4304048" y="941960"/>
                  <a:ext cx="325299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</a:t>
                  </a:r>
                </a:p>
              </p:txBody>
            </p:sp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4292654" y="1077372"/>
                  <a:ext cx="340887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3586529" y="2473833"/>
                  <a:ext cx="363163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7982175" y="1166099"/>
                  <a:ext cx="363163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7214942" y="2242618"/>
                  <a:ext cx="363163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8116894" y="3543360"/>
                  <a:ext cx="363163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3522092" y="2473833"/>
                  <a:ext cx="351432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3641868" y="5024719"/>
                  <a:ext cx="480326" cy="3335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*</a:t>
                  </a:r>
                </a:p>
                <a:p>
                  <a:endParaRPr lang="en-US" sz="700" dirty="0">
                    <a:latin typeface="Times New Roman"/>
                    <a:cs typeface="Times New Roman"/>
                  </a:endParaRP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3618284" y="2328643"/>
                  <a:ext cx="278796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</a:t>
                  </a:r>
                </a:p>
              </p:txBody>
            </p:sp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3640012" y="5172241"/>
                  <a:ext cx="363163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37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4441789" y="3825272"/>
                  <a:ext cx="363163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Connector 38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7298200" y="4901604"/>
                  <a:ext cx="363163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Connector 39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4306434" y="1895805"/>
                  <a:ext cx="183167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Connector 40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7992146" y="1743767"/>
                  <a:ext cx="183167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Connector 41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7305323" y="5056186"/>
                  <a:ext cx="183167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3586529" y="2623255"/>
                  <a:ext cx="183167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7209460" y="2092070"/>
                  <a:ext cx="423622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*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4253007" y="1762261"/>
                  <a:ext cx="475938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7284009" y="4741339"/>
                  <a:ext cx="428297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*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7903289" y="1586984"/>
                  <a:ext cx="388368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*</a:t>
                  </a: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7987213" y="1013100"/>
                  <a:ext cx="492844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*</a:t>
                  </a:r>
                </a:p>
              </p:txBody>
            </p:sp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8126866" y="3925580"/>
                  <a:ext cx="183167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Connector 51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3661904" y="5298767"/>
                  <a:ext cx="183167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xmlns="" id="{49D2B537-13BB-6045-97AA-3C22839D8ACB}"/>
                    </a:ext>
                  </a:extLst>
                </p:cNvPr>
                <p:cNvCxnSpPr/>
                <p:nvPr/>
              </p:nvCxnSpPr>
              <p:spPr>
                <a:xfrm>
                  <a:off x="4463099" y="4230381"/>
                  <a:ext cx="183167" cy="0"/>
                </a:xfrm>
                <a:prstGeom prst="line">
                  <a:avLst/>
                </a:prstGeom>
                <a:ln w="3175" cmpd="sng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4402661" y="4079939"/>
                  <a:ext cx="349729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3600602" y="5152993"/>
                  <a:ext cx="32529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</a:t>
                  </a:r>
                </a:p>
              </p:txBody>
            </p:sp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8034868" y="3775276"/>
                  <a:ext cx="386485" cy="5002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*</a:t>
                  </a:r>
                </a:p>
                <a:p>
                  <a:endParaRPr lang="en-US" sz="700" dirty="0">
                    <a:latin typeface="Times New Roman"/>
                    <a:cs typeface="Times New Roman"/>
                  </a:endParaRPr>
                </a:p>
                <a:p>
                  <a:endParaRPr lang="en-US" sz="1000" dirty="0"/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8101996" y="3407601"/>
                  <a:ext cx="378062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*</a:t>
                  </a: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4466698" y="3671920"/>
                  <a:ext cx="325299" cy="3539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</a:t>
                  </a:r>
                </a:p>
                <a:p>
                  <a:endParaRPr lang="en-US" sz="1000" dirty="0"/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xmlns="" id="{0049345E-C09F-6B4C-BB3B-AA667428CAB8}"/>
                    </a:ext>
                  </a:extLst>
                </p:cNvPr>
                <p:cNvSpPr txBox="1"/>
                <p:nvPr/>
              </p:nvSpPr>
              <p:spPr>
                <a:xfrm>
                  <a:off x="7214942" y="4901604"/>
                  <a:ext cx="397332" cy="2167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700" dirty="0">
                      <a:latin typeface="Times New Roman"/>
                      <a:cs typeface="Times New Roman"/>
                    </a:rPr>
                    <a:t>**</a:t>
                  </a:r>
                </a:p>
              </p:txBody>
            </p:sp>
          </p:grp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xmlns="" id="{EDC13271-E350-C048-9FF8-FED3FA49365D}"/>
                  </a:ext>
                </a:extLst>
              </p:cNvPr>
              <p:cNvSpPr txBox="1"/>
              <p:nvPr/>
            </p:nvSpPr>
            <p:spPr>
              <a:xfrm>
                <a:off x="3800634" y="783961"/>
                <a:ext cx="29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xmlns="" id="{EDC13271-E350-C048-9FF8-FED3FA49365D}"/>
                  </a:ext>
                </a:extLst>
              </p:cNvPr>
              <p:cNvSpPr txBox="1"/>
              <p:nvPr/>
            </p:nvSpPr>
            <p:spPr>
              <a:xfrm>
                <a:off x="6385833" y="783961"/>
                <a:ext cx="29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xmlns="" id="{EDC13271-E350-C048-9FF8-FED3FA49365D}"/>
                  </a:ext>
                </a:extLst>
              </p:cNvPr>
              <p:cNvSpPr txBox="1"/>
              <p:nvPr/>
            </p:nvSpPr>
            <p:spPr>
              <a:xfrm>
                <a:off x="3797353" y="3288050"/>
                <a:ext cx="29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6383453" y="3288050"/>
                <a:ext cx="215051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</a:p>
            </p:txBody>
          </p:sp>
        </p:grpSp>
        <p:graphicFrame>
          <p:nvGraphicFramePr>
            <p:cNvPr id="68" name="Chart 6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33955770"/>
                </p:ext>
              </p:extLst>
            </p:nvPr>
          </p:nvGraphicFramePr>
          <p:xfrm>
            <a:off x="961773" y="603110"/>
            <a:ext cx="1800000" cy="22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69" name="Chart 6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80278971"/>
                </p:ext>
              </p:extLst>
            </p:nvPr>
          </p:nvGraphicFramePr>
          <p:xfrm>
            <a:off x="3575464" y="603110"/>
            <a:ext cx="1800000" cy="226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xmlns="" id="{EDC13271-E350-C048-9FF8-FED3FA49365D}"/>
                </a:ext>
              </a:extLst>
            </p:cNvPr>
            <p:cNvSpPr txBox="1"/>
            <p:nvPr/>
          </p:nvSpPr>
          <p:spPr>
            <a:xfrm>
              <a:off x="3466793" y="464610"/>
              <a:ext cx="287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xmlns="" id="{EDC13271-E350-C048-9FF8-FED3FA49365D}"/>
                </a:ext>
              </a:extLst>
            </p:cNvPr>
            <p:cNvSpPr txBox="1"/>
            <p:nvPr/>
          </p:nvSpPr>
          <p:spPr>
            <a:xfrm>
              <a:off x="818119" y="464610"/>
              <a:ext cx="287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38928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9B354175-B6D0-E24E-AFA3-1F69AFBD071F}"/>
              </a:ext>
            </a:extLst>
          </p:cNvPr>
          <p:cNvSpPr txBox="1"/>
          <p:nvPr/>
        </p:nvSpPr>
        <p:spPr>
          <a:xfrm>
            <a:off x="3019611" y="2455183"/>
            <a:ext cx="819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8917010"/>
              </p:ext>
            </p:extLst>
          </p:nvPr>
        </p:nvGraphicFramePr>
        <p:xfrm>
          <a:off x="3788779" y="605561"/>
          <a:ext cx="2655104" cy="137584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4146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5354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68810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7199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282391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Sample 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MFI</a:t>
                      </a:r>
                      <a:r>
                        <a:rPr lang="en-US" sz="800" b="1" baseline="0" dirty="0"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Day 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MFI</a:t>
                      </a:r>
                      <a:r>
                        <a:rPr lang="en-US" sz="800" b="1" baseline="0" dirty="0"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Day</a:t>
                      </a:r>
                      <a:r>
                        <a:rPr lang="en-US" sz="800" b="1" baseline="0" dirty="0"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79703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Untreat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19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19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79703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PM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248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3185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22245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A+D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134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2501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22245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A+RA8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1438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2388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22245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A+RA839+D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114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208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E49C74A4-EDD2-4427-883C-C7FE4FC5DE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0034" y="928630"/>
            <a:ext cx="144000" cy="1296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xmlns="" id="{BF3C9C22-1F17-42E4-92FD-9DF310DFDC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48607" y="1134468"/>
            <a:ext cx="142157" cy="143998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EA8DDBBF-528F-4A50-8167-893BDE8E1D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2476" y="1358916"/>
            <a:ext cx="133387" cy="143999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C1152950-E123-418C-9FF5-D2FD044013D4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855152" y="1587715"/>
            <a:ext cx="143999" cy="143999"/>
          </a:xfrm>
          <a:prstGeom prst="rect">
            <a:avLst/>
          </a:prstGeom>
        </p:spPr>
      </p:pic>
      <p:grpSp>
        <p:nvGrpSpPr>
          <p:cNvPr id="24" name="Group 23"/>
          <p:cNvGrpSpPr/>
          <p:nvPr/>
        </p:nvGrpSpPr>
        <p:grpSpPr>
          <a:xfrm>
            <a:off x="1165027" y="359339"/>
            <a:ext cx="2004868" cy="248861"/>
            <a:chOff x="1018091" y="2521776"/>
            <a:chExt cx="2004868" cy="248861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9242888B-B53F-4E46-B341-C6DB4709C01F}"/>
                </a:ext>
              </a:extLst>
            </p:cNvPr>
            <p:cNvSpPr txBox="1"/>
            <p:nvPr/>
          </p:nvSpPr>
          <p:spPr>
            <a:xfrm>
              <a:off x="1018091" y="2521776"/>
              <a:ext cx="774655" cy="24622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3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9242888B-B53F-4E46-B341-C6DB4709C01F}"/>
                </a:ext>
              </a:extLst>
            </p:cNvPr>
            <p:cNvSpPr txBox="1"/>
            <p:nvPr/>
          </p:nvSpPr>
          <p:spPr>
            <a:xfrm>
              <a:off x="2248304" y="2524415"/>
              <a:ext cx="774655" cy="24622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6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9B354175-B6D0-E24E-AFA3-1F69AFBD071F}"/>
              </a:ext>
            </a:extLst>
          </p:cNvPr>
          <p:cNvSpPr txBox="1"/>
          <p:nvPr/>
        </p:nvSpPr>
        <p:spPr>
          <a:xfrm>
            <a:off x="3019611" y="5082158"/>
            <a:ext cx="819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xmlns="" id="{E6C90E22-D82D-4CB9-BE10-F925B656F08C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855183" y="1799034"/>
            <a:ext cx="120960" cy="144000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520066" y="3068297"/>
            <a:ext cx="2982468" cy="1971403"/>
            <a:chOff x="603010" y="3068297"/>
            <a:chExt cx="2982468" cy="1971403"/>
          </a:xfrm>
        </p:grpSpPr>
        <p:grpSp>
          <p:nvGrpSpPr>
            <p:cNvPr id="37" name="Group 36"/>
            <p:cNvGrpSpPr/>
            <p:nvPr/>
          </p:nvGrpSpPr>
          <p:grpSpPr>
            <a:xfrm>
              <a:off x="1266059" y="3068297"/>
              <a:ext cx="2004868" cy="248861"/>
              <a:chOff x="1018091" y="2538486"/>
              <a:chExt cx="2004868" cy="248861"/>
            </a:xfrm>
          </p:grpSpPr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xmlns="" id="{9242888B-B53F-4E46-B341-C6DB4709C01F}"/>
                  </a:ext>
                </a:extLst>
              </p:cNvPr>
              <p:cNvSpPr txBox="1"/>
              <p:nvPr/>
            </p:nvSpPr>
            <p:spPr>
              <a:xfrm>
                <a:off x="1018091" y="2538486"/>
                <a:ext cx="774655" cy="246222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3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xmlns="" id="{9242888B-B53F-4E46-B341-C6DB4709C01F}"/>
                  </a:ext>
                </a:extLst>
              </p:cNvPr>
              <p:cNvSpPr txBox="1"/>
              <p:nvPr/>
            </p:nvSpPr>
            <p:spPr>
              <a:xfrm>
                <a:off x="2248304" y="2541125"/>
                <a:ext cx="774655" cy="246222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6</a:t>
                </a:r>
              </a:p>
            </p:txBody>
          </p:sp>
        </p:grpSp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xmlns="" id="{992F7316-91AD-4099-892C-508CE87A88B2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3559" t="2347" r="76781" b="47815"/>
            <a:stretch/>
          </p:blipFill>
          <p:spPr>
            <a:xfrm>
              <a:off x="928364" y="3298641"/>
              <a:ext cx="1332000" cy="1476000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xmlns="" id="{992F7316-91AD-4099-892C-508CE87A88B2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53149" t="2939" r="27131" b="47815"/>
            <a:stretch/>
          </p:blipFill>
          <p:spPr>
            <a:xfrm>
              <a:off x="2253478" y="3311393"/>
              <a:ext cx="1332000" cy="1455960"/>
            </a:xfrm>
            <a:prstGeom prst="rect">
              <a:avLst/>
            </a:prstGeom>
          </p:spPr>
        </p:pic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xmlns="" id="{BFD16A15-B9BD-4356-AA5E-CCEA0780433F}"/>
                </a:ext>
              </a:extLst>
            </p:cNvPr>
            <p:cNvSpPr txBox="1"/>
            <p:nvPr/>
          </p:nvSpPr>
          <p:spPr>
            <a:xfrm rot="16200000">
              <a:off x="384392" y="3887172"/>
              <a:ext cx="683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ents</a:t>
              </a:r>
            </a:p>
          </p:txBody>
        </p: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xmlns="" id="{91622416-FF54-4E78-8C26-B81310E23979}"/>
                </a:ext>
              </a:extLst>
            </p:cNvPr>
            <p:cNvCxnSpPr/>
            <p:nvPr/>
          </p:nvCxnSpPr>
          <p:spPr>
            <a:xfrm flipV="1">
              <a:off x="863116" y="3321025"/>
              <a:ext cx="0" cy="125999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xmlns="" id="{5D78C709-6D83-4232-A8C6-1DEA1EB3F73E}"/>
                </a:ext>
              </a:extLst>
            </p:cNvPr>
            <p:cNvCxnSpPr/>
            <p:nvPr/>
          </p:nvCxnSpPr>
          <p:spPr>
            <a:xfrm>
              <a:off x="1009246" y="4796252"/>
              <a:ext cx="251996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1386561" y="4793479"/>
              <a:ext cx="16163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Times New Roman"/>
                  <a:cs typeface="Times New Roman"/>
                </a:rPr>
                <a:t> ROS-FITC (MFI)</a:t>
              </a:r>
            </a:p>
          </p:txBody>
        </p:sp>
      </p:grpSp>
      <p:graphicFrame>
        <p:nvGraphicFramePr>
          <p:cNvPr id="50" name="Table 4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7532049"/>
              </p:ext>
            </p:extLst>
          </p:nvPr>
        </p:nvGraphicFramePr>
        <p:xfrm>
          <a:off x="3788779" y="3321278"/>
          <a:ext cx="2738121" cy="135406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4901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8648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0962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9300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275909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Sample 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MFI</a:t>
                      </a:r>
                      <a:r>
                        <a:rPr lang="en-US" sz="800" b="1" baseline="0" dirty="0"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Day 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MFI</a:t>
                      </a:r>
                      <a:r>
                        <a:rPr lang="en-US" sz="800" b="1" baseline="0" dirty="0"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Day</a:t>
                      </a:r>
                      <a:r>
                        <a:rPr lang="en-US" sz="800" b="1" baseline="0" dirty="0"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800" b="1" dirty="0">
                          <a:latin typeface="Times New Roman"/>
                          <a:cs typeface="Times New Roman"/>
                        </a:rPr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8463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Untreat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19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19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8463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PM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248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3185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17144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A+D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134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2501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17144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A+ML3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369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471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17144">
                <a:tc>
                  <a:txBody>
                    <a:bodyPr/>
                    <a:lstStyle/>
                    <a:p>
                      <a:endParaRPr lang="en-US" sz="8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A+ML385+D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2254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/>
                          <a:cs typeface="Times New Roman"/>
                        </a:rPr>
                        <a:t>3505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pic>
        <p:nvPicPr>
          <p:cNvPr id="51" name="Picture 50">
            <a:extLst>
              <a:ext uri="{FF2B5EF4-FFF2-40B4-BE49-F238E27FC236}">
                <a16:creationId xmlns:a16="http://schemas.microsoft.com/office/drawing/2014/main" xmlns="" id="{E49C74A4-EDD2-4427-883C-C7FE4FC5DE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0034" y="3644347"/>
            <a:ext cx="144000" cy="12960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xmlns="" id="{BF3C9C22-1F17-42E4-92FD-9DF310DFDC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48607" y="3850185"/>
            <a:ext cx="142157" cy="143998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xmlns="" id="{EA8DDBBF-528F-4A50-8167-893BDE8E1D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2476" y="4074633"/>
            <a:ext cx="133387" cy="143999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xmlns="" id="{C1152950-E123-418C-9FF5-D2FD044013D4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855152" y="4303432"/>
            <a:ext cx="143999" cy="143999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xmlns="" id="{E6C90E22-D82D-4CB9-BE10-F925B656F08C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855183" y="4501167"/>
            <a:ext cx="120960" cy="1440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xmlns="" id="{3D6A72AB-647F-498E-BAFE-B8DC47DA8D36}"/>
              </a:ext>
            </a:extLst>
          </p:cNvPr>
          <p:cNvPicPr>
            <a:picLocks/>
          </p:cNvPicPr>
          <p:nvPr/>
        </p:nvPicPr>
        <p:blipFill rotWithShape="1">
          <a:blip r:embed="rId9"/>
          <a:srcRect l="3744" t="2896" r="74892" b="48334"/>
          <a:stretch/>
        </p:blipFill>
        <p:spPr>
          <a:xfrm>
            <a:off x="796738" y="600460"/>
            <a:ext cx="1332000" cy="147600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xmlns="" id="{3D6A72AB-647F-498E-BAFE-B8DC47DA8D36}"/>
              </a:ext>
            </a:extLst>
          </p:cNvPr>
          <p:cNvPicPr>
            <a:picLocks/>
          </p:cNvPicPr>
          <p:nvPr/>
        </p:nvPicPr>
        <p:blipFill rotWithShape="1">
          <a:blip r:embed="rId9"/>
          <a:srcRect l="55062" t="2896" r="23463" b="48334"/>
          <a:stretch/>
        </p:blipFill>
        <p:spPr>
          <a:xfrm>
            <a:off x="2117776" y="605561"/>
            <a:ext cx="1332000" cy="1476000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BFD16A15-B9BD-4356-AA5E-CCEA0780433F}"/>
              </a:ext>
            </a:extLst>
          </p:cNvPr>
          <p:cNvSpPr txBox="1"/>
          <p:nvPr/>
        </p:nvSpPr>
        <p:spPr>
          <a:xfrm rot="16200000">
            <a:off x="262984" y="1194924"/>
            <a:ext cx="6834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ents</a:t>
            </a: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xmlns="" id="{91622416-FF54-4E78-8C26-B81310E23979}"/>
              </a:ext>
            </a:extLst>
          </p:cNvPr>
          <p:cNvCxnSpPr/>
          <p:nvPr/>
        </p:nvCxnSpPr>
        <p:spPr>
          <a:xfrm flipV="1">
            <a:off x="741708" y="628777"/>
            <a:ext cx="0" cy="12599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xmlns="" id="{5D78C709-6D83-4232-A8C6-1DEA1EB3F73E}"/>
              </a:ext>
            </a:extLst>
          </p:cNvPr>
          <p:cNvCxnSpPr/>
          <p:nvPr/>
        </p:nvCxnSpPr>
        <p:spPr>
          <a:xfrm>
            <a:off x="908214" y="2113922"/>
            <a:ext cx="251996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1285529" y="2111149"/>
            <a:ext cx="16163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/>
                <a:cs typeface="Times New Roman"/>
              </a:rPr>
              <a:t> ROS-FITC (MFI)</a:t>
            </a:r>
          </a:p>
        </p:txBody>
      </p:sp>
    </p:spTree>
    <p:extLst>
      <p:ext uri="{BB962C8B-B14F-4D97-AF65-F5344CB8AC3E}">
        <p14:creationId xmlns:p14="http://schemas.microsoft.com/office/powerpoint/2010/main" val="2001803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64</TotalTime>
  <Words>246</Words>
  <Application>Microsoft Macintosh PowerPoint</Application>
  <PresentationFormat>On-screen Show (4:3)</PresentationFormat>
  <Paragraphs>120</Paragraphs>
  <Slides>4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Sankar</dc:creator>
  <cp:keywords/>
  <dc:description/>
  <cp:lastModifiedBy>Dr. Sankar</cp:lastModifiedBy>
  <cp:revision>497</cp:revision>
  <dcterms:created xsi:type="dcterms:W3CDTF">2020-04-01T05:50:11Z</dcterms:created>
  <dcterms:modified xsi:type="dcterms:W3CDTF">2021-11-29T10:19:05Z</dcterms:modified>
  <cp:category/>
</cp:coreProperties>
</file>